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497" autoAdjust="0"/>
  </p:normalViewPr>
  <p:slideViewPr>
    <p:cSldViewPr snapToGrid="0" snapToObjects="1">
      <p:cViewPr>
        <p:scale>
          <a:sx n="100" d="100"/>
          <a:sy n="100" d="100"/>
        </p:scale>
        <p:origin x="-930" y="-29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in:Users:anthonyarnoldo:Desktop:RHOXF2%20shRNA:RHOXF2_shRNA_SW1353_Cisplatin_MitomycinC_Camptothecin:RHOXF2shRNA_SW1353_Statistic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in:Users:anthonyarnoldo:Desktop:RHOXF2%20shRNA:RHOXF2_shRNA_SW1353_Cisplatin_MitomycinC_Camptothecin:RHOXF2shRNA_SW1353_Statistic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in:Users:anthonyarnoldo:Desktop:RHOXF2%20shRNA:RHOXF2_shRNA_H1299_Cisplatin_MitomycinC_Methotrexate:RHOXF2shRNA_H1299_Statistic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in:Users:anthonyarnoldo:Desktop:RHOXF2%20shRNA:RHOXF2_shRNA_H1299_Cisplatin_MitomycinC_Methotrexate:RHOXF2shRNA_H1299_Statistic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in:Users:anthonyarnoldo:Desktop:RHOXF2%20shRNA:RHOXF2_shRNA_HPAC_Cisplatin_MitomycinC_Methotrexate_Camptothecin:11_09_RHOXF2shRNA_K562_Statistics%20copy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in:Users:anthonyarnoldo:Desktop:RHOXF2%20shRNA:RHOXF2_shRNA_HPAC_Cisplatin_MitomycinC_Methotrexate_Camptothecin:11_09_RHOXF2shRNA_K562_Statistics%20cop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035001743663201E-2"/>
          <c:y val="1.9938625496586301E-2"/>
          <c:w val="0.88657673711838603"/>
          <c:h val="0.96012269938650296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1!$C$60</c:f>
              <c:strCache>
                <c:ptCount val="1"/>
                <c:pt idx="0">
                  <c:v>Cisplatin inhibition RHOXF2-shRNA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89:$C$99</c:f>
                <c:numCache>
                  <c:formatCode>General</c:formatCode>
                  <c:ptCount val="11"/>
                  <c:pt idx="0">
                    <c:v>2.4111959451209928</c:v>
                  </c:pt>
                  <c:pt idx="1">
                    <c:v>1.7590648347669211</c:v>
                  </c:pt>
                  <c:pt idx="2">
                    <c:v>1.931961525504309</c:v>
                  </c:pt>
                  <c:pt idx="3">
                    <c:v>3.9133543324006892</c:v>
                  </c:pt>
                  <c:pt idx="4">
                    <c:v>4.4568441165022623</c:v>
                  </c:pt>
                  <c:pt idx="5">
                    <c:v>6.0004821491480627</c:v>
                  </c:pt>
                  <c:pt idx="6">
                    <c:v>5.0094613419815408</c:v>
                  </c:pt>
                  <c:pt idx="7">
                    <c:v>4.2224679323854746</c:v>
                  </c:pt>
                  <c:pt idx="8">
                    <c:v>3.1462818405131752</c:v>
                  </c:pt>
                  <c:pt idx="9">
                    <c:v>2.5138843061061249</c:v>
                  </c:pt>
                  <c:pt idx="10">
                    <c:v>3.027666713157116</c:v>
                  </c:pt>
                </c:numCache>
              </c:numRef>
            </c:plus>
            <c:minus>
              <c:numRef>
                <c:f>Sheet1!$C$89:$C$99</c:f>
                <c:numCache>
                  <c:formatCode>General</c:formatCode>
                  <c:ptCount val="11"/>
                  <c:pt idx="0">
                    <c:v>2.4111959451209928</c:v>
                  </c:pt>
                  <c:pt idx="1">
                    <c:v>1.7590648347669211</c:v>
                  </c:pt>
                  <c:pt idx="2">
                    <c:v>1.931961525504309</c:v>
                  </c:pt>
                  <c:pt idx="3">
                    <c:v>3.9133543324006892</c:v>
                  </c:pt>
                  <c:pt idx="4">
                    <c:v>4.4568441165022623</c:v>
                  </c:pt>
                  <c:pt idx="5">
                    <c:v>6.0004821491480627</c:v>
                  </c:pt>
                  <c:pt idx="6">
                    <c:v>5.0094613419815408</c:v>
                  </c:pt>
                  <c:pt idx="7">
                    <c:v>4.2224679323854746</c:v>
                  </c:pt>
                  <c:pt idx="8">
                    <c:v>3.1462818405131752</c:v>
                  </c:pt>
                  <c:pt idx="9">
                    <c:v>2.5138843061061249</c:v>
                  </c:pt>
                  <c:pt idx="10">
                    <c:v>3.027666713157116</c:v>
                  </c:pt>
                </c:numCache>
              </c:numRef>
            </c:minus>
          </c:errBars>
          <c:xVal>
            <c:numRef>
              <c:f>Sheet1!$A$61:$A$71</c:f>
              <c:numCache>
                <c:formatCode>General</c:formatCode>
                <c:ptCount val="11"/>
                <c:pt idx="0">
                  <c:v>200</c:v>
                </c:pt>
                <c:pt idx="1">
                  <c:v>100</c:v>
                </c:pt>
                <c:pt idx="2">
                  <c:v>50</c:v>
                </c:pt>
                <c:pt idx="3">
                  <c:v>25</c:v>
                </c:pt>
                <c:pt idx="4">
                  <c:v>12.5</c:v>
                </c:pt>
                <c:pt idx="5">
                  <c:v>6.25</c:v>
                </c:pt>
                <c:pt idx="6">
                  <c:v>3.125</c:v>
                </c:pt>
                <c:pt idx="7">
                  <c:v>1.5625</c:v>
                </c:pt>
                <c:pt idx="8">
                  <c:v>0.78125</c:v>
                </c:pt>
                <c:pt idx="9">
                  <c:v>0.390625</c:v>
                </c:pt>
                <c:pt idx="10">
                  <c:v>0.1953125</c:v>
                </c:pt>
              </c:numCache>
            </c:numRef>
          </c:xVal>
          <c:yVal>
            <c:numRef>
              <c:f>Sheet1!$C$61:$C$71</c:f>
              <c:numCache>
                <c:formatCode>General</c:formatCode>
                <c:ptCount val="11"/>
                <c:pt idx="0">
                  <c:v>69.545314110597445</c:v>
                </c:pt>
                <c:pt idx="1">
                  <c:v>72.012420516621631</c:v>
                </c:pt>
                <c:pt idx="2">
                  <c:v>78.469281160316598</c:v>
                </c:pt>
                <c:pt idx="3">
                  <c:v>68.217748629173201</c:v>
                </c:pt>
                <c:pt idx="4">
                  <c:v>44.2299169826913</c:v>
                </c:pt>
                <c:pt idx="5">
                  <c:v>26.666021840965559</c:v>
                </c:pt>
                <c:pt idx="6">
                  <c:v>15.77843028592523</c:v>
                </c:pt>
                <c:pt idx="7">
                  <c:v>12.377707743211671</c:v>
                </c:pt>
                <c:pt idx="8">
                  <c:v>12.27113511352033</c:v>
                </c:pt>
                <c:pt idx="9">
                  <c:v>8.7995689311617209</c:v>
                </c:pt>
                <c:pt idx="10">
                  <c:v>18.94962371251578</c:v>
                </c:pt>
              </c:numCache>
            </c:numRef>
          </c:yVal>
          <c:smooth val="1"/>
        </c:ser>
        <c:ser>
          <c:idx val="5"/>
          <c:order val="1"/>
          <c:tx>
            <c:strRef>
              <c:f>Sheet1!$G$60</c:f>
              <c:strCache>
                <c:ptCount val="1"/>
                <c:pt idx="0">
                  <c:v>Cisplatin inhibition RHOXF2-GFP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89:$G$99</c:f>
                <c:numCache>
                  <c:formatCode>General</c:formatCode>
                  <c:ptCount val="11"/>
                  <c:pt idx="0">
                    <c:v>1.5856674126927059</c:v>
                  </c:pt>
                  <c:pt idx="1">
                    <c:v>1.8953582742249599</c:v>
                  </c:pt>
                  <c:pt idx="2">
                    <c:v>3.0225724004272969</c:v>
                  </c:pt>
                  <c:pt idx="3">
                    <c:v>3.9764298639339102</c:v>
                  </c:pt>
                  <c:pt idx="4">
                    <c:v>3.9457899898392998</c:v>
                  </c:pt>
                  <c:pt idx="5">
                    <c:v>3.7820406551057291</c:v>
                  </c:pt>
                  <c:pt idx="6">
                    <c:v>2.7686991506725169</c:v>
                  </c:pt>
                  <c:pt idx="7">
                    <c:v>2.3773677575414012</c:v>
                  </c:pt>
                  <c:pt idx="8">
                    <c:v>3.577151576555778</c:v>
                  </c:pt>
                  <c:pt idx="9">
                    <c:v>2.668811507554568</c:v>
                  </c:pt>
                  <c:pt idx="10">
                    <c:v>2.2448924605079879</c:v>
                  </c:pt>
                </c:numCache>
              </c:numRef>
            </c:plus>
            <c:minus>
              <c:numRef>
                <c:f>Sheet1!$G$89:$G$99</c:f>
                <c:numCache>
                  <c:formatCode>General</c:formatCode>
                  <c:ptCount val="11"/>
                  <c:pt idx="0">
                    <c:v>1.5856674126927059</c:v>
                  </c:pt>
                  <c:pt idx="1">
                    <c:v>1.8953582742249599</c:v>
                  </c:pt>
                  <c:pt idx="2">
                    <c:v>3.0225724004272969</c:v>
                  </c:pt>
                  <c:pt idx="3">
                    <c:v>3.9764298639339102</c:v>
                  </c:pt>
                  <c:pt idx="4">
                    <c:v>3.9457899898392998</c:v>
                  </c:pt>
                  <c:pt idx="5">
                    <c:v>3.7820406551057291</c:v>
                  </c:pt>
                  <c:pt idx="6">
                    <c:v>2.7686991506725169</c:v>
                  </c:pt>
                  <c:pt idx="7">
                    <c:v>2.3773677575414012</c:v>
                  </c:pt>
                  <c:pt idx="8">
                    <c:v>3.577151576555778</c:v>
                  </c:pt>
                  <c:pt idx="9">
                    <c:v>2.668811507554568</c:v>
                  </c:pt>
                  <c:pt idx="10">
                    <c:v>2.2448924605079879</c:v>
                  </c:pt>
                </c:numCache>
              </c:numRef>
            </c:minus>
          </c:errBars>
          <c:xVal>
            <c:numRef>
              <c:f>Sheet1!$A$61:$A$71</c:f>
              <c:numCache>
                <c:formatCode>General</c:formatCode>
                <c:ptCount val="11"/>
                <c:pt idx="0">
                  <c:v>200</c:v>
                </c:pt>
                <c:pt idx="1">
                  <c:v>100</c:v>
                </c:pt>
                <c:pt idx="2">
                  <c:v>50</c:v>
                </c:pt>
                <c:pt idx="3">
                  <c:v>25</c:v>
                </c:pt>
                <c:pt idx="4">
                  <c:v>12.5</c:v>
                </c:pt>
                <c:pt idx="5">
                  <c:v>6.25</c:v>
                </c:pt>
                <c:pt idx="6">
                  <c:v>3.125</c:v>
                </c:pt>
                <c:pt idx="7">
                  <c:v>1.5625</c:v>
                </c:pt>
                <c:pt idx="8">
                  <c:v>0.78125</c:v>
                </c:pt>
                <c:pt idx="9">
                  <c:v>0.390625</c:v>
                </c:pt>
                <c:pt idx="10">
                  <c:v>0.1953125</c:v>
                </c:pt>
              </c:numCache>
            </c:numRef>
          </c:xVal>
          <c:yVal>
            <c:numRef>
              <c:f>Sheet1!$G$61:$G$71</c:f>
              <c:numCache>
                <c:formatCode>General</c:formatCode>
                <c:ptCount val="11"/>
                <c:pt idx="0">
                  <c:v>65.39521678220683</c:v>
                </c:pt>
                <c:pt idx="1">
                  <c:v>69.831808548681295</c:v>
                </c:pt>
                <c:pt idx="2">
                  <c:v>69.713065908967494</c:v>
                </c:pt>
                <c:pt idx="3">
                  <c:v>58.718035128197862</c:v>
                </c:pt>
                <c:pt idx="4">
                  <c:v>39.719349171174322</c:v>
                </c:pt>
                <c:pt idx="5">
                  <c:v>20.847745926530589</c:v>
                </c:pt>
                <c:pt idx="6">
                  <c:v>17.073640829428111</c:v>
                </c:pt>
                <c:pt idx="7">
                  <c:v>17.17178019232577</c:v>
                </c:pt>
                <c:pt idx="8">
                  <c:v>13.34031872766808</c:v>
                </c:pt>
                <c:pt idx="9">
                  <c:v>12.357423173008319</c:v>
                </c:pt>
                <c:pt idx="10">
                  <c:v>16.1520299527206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114880"/>
        <c:axId val="69124864"/>
      </c:scatterChart>
      <c:valAx>
        <c:axId val="69114880"/>
        <c:scaling>
          <c:logBase val="2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9124864"/>
        <c:crosses val="autoZero"/>
        <c:crossBetween val="midCat"/>
      </c:valAx>
      <c:valAx>
        <c:axId val="6912486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69114880"/>
        <c:crossesAt val="0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6.8257490540955104E-2"/>
          <c:y val="3.55191256830601E-2"/>
          <c:w val="0.81550328936155703"/>
          <c:h val="0.89522783012779095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1!$AJ$60</c:f>
              <c:strCache>
                <c:ptCount val="1"/>
                <c:pt idx="0">
                  <c:v>Mitomycin C inhibition RHOXF2-shRNA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J$89:$AJ$99</c:f>
                <c:numCache>
                  <c:formatCode>General</c:formatCode>
                  <c:ptCount val="11"/>
                  <c:pt idx="0">
                    <c:v>5.5375953468951744</c:v>
                  </c:pt>
                  <c:pt idx="1">
                    <c:v>4.2327301723160886</c:v>
                  </c:pt>
                  <c:pt idx="2">
                    <c:v>3.0795634435209398</c:v>
                  </c:pt>
                  <c:pt idx="3">
                    <c:v>0.731920166016364</c:v>
                  </c:pt>
                  <c:pt idx="4">
                    <c:v>2.9283718353321042</c:v>
                  </c:pt>
                  <c:pt idx="5">
                    <c:v>5.0819718509896727</c:v>
                  </c:pt>
                  <c:pt idx="6">
                    <c:v>5.5793617560499227</c:v>
                  </c:pt>
                  <c:pt idx="7">
                    <c:v>4.9223712720262833</c:v>
                  </c:pt>
                  <c:pt idx="8">
                    <c:v>2.3592513621376301</c:v>
                  </c:pt>
                  <c:pt idx="9">
                    <c:v>1.4997116994288919</c:v>
                  </c:pt>
                  <c:pt idx="10">
                    <c:v>2.3395887993137361</c:v>
                  </c:pt>
                </c:numCache>
              </c:numRef>
            </c:plus>
            <c:minus>
              <c:numRef>
                <c:f>Sheet1!$AJ$89:$AJ$99</c:f>
                <c:numCache>
                  <c:formatCode>General</c:formatCode>
                  <c:ptCount val="11"/>
                  <c:pt idx="0">
                    <c:v>5.5375953468951744</c:v>
                  </c:pt>
                  <c:pt idx="1">
                    <c:v>4.2327301723160886</c:v>
                  </c:pt>
                  <c:pt idx="2">
                    <c:v>3.0795634435209398</c:v>
                  </c:pt>
                  <c:pt idx="3">
                    <c:v>0.731920166016364</c:v>
                  </c:pt>
                  <c:pt idx="4">
                    <c:v>2.9283718353321042</c:v>
                  </c:pt>
                  <c:pt idx="5">
                    <c:v>5.0819718509896727</c:v>
                  </c:pt>
                  <c:pt idx="6">
                    <c:v>5.5793617560499227</c:v>
                  </c:pt>
                  <c:pt idx="7">
                    <c:v>4.9223712720262833</c:v>
                  </c:pt>
                  <c:pt idx="8">
                    <c:v>2.3592513621376301</c:v>
                  </c:pt>
                  <c:pt idx="9">
                    <c:v>1.4997116994288919</c:v>
                  </c:pt>
                  <c:pt idx="10">
                    <c:v>2.3395887993137361</c:v>
                  </c:pt>
                </c:numCache>
              </c:numRef>
            </c:minus>
          </c:errBars>
          <c:xVal>
            <c:numRef>
              <c:f>Sheet1!$AH$61:$AH$71</c:f>
              <c:numCache>
                <c:formatCode>General</c:formatCode>
                <c:ptCount val="11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2.5</c:v>
                </c:pt>
                <c:pt idx="4">
                  <c:v>1.25</c:v>
                </c:pt>
                <c:pt idx="5">
                  <c:v>0.625</c:v>
                </c:pt>
                <c:pt idx="6">
                  <c:v>0.3125</c:v>
                </c:pt>
                <c:pt idx="7">
                  <c:v>0.15625</c:v>
                </c:pt>
                <c:pt idx="8">
                  <c:v>7.8125E-2</c:v>
                </c:pt>
                <c:pt idx="9">
                  <c:v>3.90625E-2</c:v>
                </c:pt>
                <c:pt idx="10">
                  <c:v>1.953125E-2</c:v>
                </c:pt>
              </c:numCache>
            </c:numRef>
          </c:xVal>
          <c:yVal>
            <c:numRef>
              <c:f>Sheet1!$AJ$61:$AJ$71</c:f>
              <c:numCache>
                <c:formatCode>General</c:formatCode>
                <c:ptCount val="11"/>
                <c:pt idx="0">
                  <c:v>77.394795334981396</c:v>
                </c:pt>
                <c:pt idx="1">
                  <c:v>78.015221669978899</c:v>
                </c:pt>
                <c:pt idx="2">
                  <c:v>78.670808116172182</c:v>
                </c:pt>
                <c:pt idx="3">
                  <c:v>66.635449434441568</c:v>
                </c:pt>
                <c:pt idx="4">
                  <c:v>47.018902357616042</c:v>
                </c:pt>
                <c:pt idx="5">
                  <c:v>31.850798940320061</c:v>
                </c:pt>
                <c:pt idx="6">
                  <c:v>21.94029633406678</c:v>
                </c:pt>
                <c:pt idx="7">
                  <c:v>21.19957855784547</c:v>
                </c:pt>
                <c:pt idx="8">
                  <c:v>17.153768634044781</c:v>
                </c:pt>
                <c:pt idx="9">
                  <c:v>13.19812656375916</c:v>
                </c:pt>
                <c:pt idx="10">
                  <c:v>19.89192901641324</c:v>
                </c:pt>
              </c:numCache>
            </c:numRef>
          </c:yVal>
          <c:smooth val="1"/>
        </c:ser>
        <c:ser>
          <c:idx val="5"/>
          <c:order val="1"/>
          <c:tx>
            <c:strRef>
              <c:f>Sheet1!$AN$60</c:f>
              <c:strCache>
                <c:ptCount val="1"/>
                <c:pt idx="0">
                  <c:v>Cisplatin inhibition RHOXF2-GFP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N$89:$AN$99</c:f>
                <c:numCache>
                  <c:formatCode>General</c:formatCode>
                  <c:ptCount val="11"/>
                  <c:pt idx="0">
                    <c:v>4.6236931069465772</c:v>
                  </c:pt>
                  <c:pt idx="1">
                    <c:v>3.2743155692569061</c:v>
                  </c:pt>
                  <c:pt idx="2">
                    <c:v>3.1685794637835381</c:v>
                  </c:pt>
                  <c:pt idx="3">
                    <c:v>3.5549229391967301</c:v>
                  </c:pt>
                  <c:pt idx="4">
                    <c:v>4.9659899440286566</c:v>
                  </c:pt>
                  <c:pt idx="5">
                    <c:v>5.8511374485923868</c:v>
                  </c:pt>
                  <c:pt idx="6">
                    <c:v>4.5703188064897056</c:v>
                  </c:pt>
                  <c:pt idx="7">
                    <c:v>2.8305169586939698</c:v>
                  </c:pt>
                  <c:pt idx="8">
                    <c:v>4.0828426506028741</c:v>
                  </c:pt>
                  <c:pt idx="9">
                    <c:v>2.8072955976369252</c:v>
                  </c:pt>
                  <c:pt idx="10">
                    <c:v>1.3702602663197281</c:v>
                  </c:pt>
                </c:numCache>
              </c:numRef>
            </c:plus>
            <c:minus>
              <c:numRef>
                <c:f>Sheet1!$AN$89:$AN$99</c:f>
                <c:numCache>
                  <c:formatCode>General</c:formatCode>
                  <c:ptCount val="11"/>
                  <c:pt idx="0">
                    <c:v>4.6236931069465772</c:v>
                  </c:pt>
                  <c:pt idx="1">
                    <c:v>3.2743155692569061</c:v>
                  </c:pt>
                  <c:pt idx="2">
                    <c:v>3.1685794637835381</c:v>
                  </c:pt>
                  <c:pt idx="3">
                    <c:v>3.5549229391967301</c:v>
                  </c:pt>
                  <c:pt idx="4">
                    <c:v>4.9659899440286566</c:v>
                  </c:pt>
                  <c:pt idx="5">
                    <c:v>5.8511374485923868</c:v>
                  </c:pt>
                  <c:pt idx="6">
                    <c:v>4.5703188064897056</c:v>
                  </c:pt>
                  <c:pt idx="7">
                    <c:v>2.8305169586939698</c:v>
                  </c:pt>
                  <c:pt idx="8">
                    <c:v>4.0828426506028741</c:v>
                  </c:pt>
                  <c:pt idx="9">
                    <c:v>2.8072955976369252</c:v>
                  </c:pt>
                  <c:pt idx="10">
                    <c:v>1.3702602663197281</c:v>
                  </c:pt>
                </c:numCache>
              </c:numRef>
            </c:minus>
          </c:errBars>
          <c:xVal>
            <c:numRef>
              <c:f>Sheet1!$AH$61:$AH$71</c:f>
              <c:numCache>
                <c:formatCode>General</c:formatCode>
                <c:ptCount val="11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2.5</c:v>
                </c:pt>
                <c:pt idx="4">
                  <c:v>1.25</c:v>
                </c:pt>
                <c:pt idx="5">
                  <c:v>0.625</c:v>
                </c:pt>
                <c:pt idx="6">
                  <c:v>0.3125</c:v>
                </c:pt>
                <c:pt idx="7">
                  <c:v>0.15625</c:v>
                </c:pt>
                <c:pt idx="8">
                  <c:v>7.8125E-2</c:v>
                </c:pt>
                <c:pt idx="9">
                  <c:v>3.90625E-2</c:v>
                </c:pt>
                <c:pt idx="10">
                  <c:v>1.953125E-2</c:v>
                </c:pt>
              </c:numCache>
            </c:numRef>
          </c:xVal>
          <c:yVal>
            <c:numRef>
              <c:f>Sheet1!$AN$61:$AN$71</c:f>
              <c:numCache>
                <c:formatCode>General</c:formatCode>
                <c:ptCount val="11"/>
                <c:pt idx="0">
                  <c:v>71.427487177767375</c:v>
                </c:pt>
                <c:pt idx="1">
                  <c:v>72.840861364060316</c:v>
                </c:pt>
                <c:pt idx="2">
                  <c:v>71.599506446920785</c:v>
                </c:pt>
                <c:pt idx="3">
                  <c:v>62.400728199044373</c:v>
                </c:pt>
                <c:pt idx="4">
                  <c:v>44.974792765606892</c:v>
                </c:pt>
                <c:pt idx="5">
                  <c:v>30.328541291437279</c:v>
                </c:pt>
                <c:pt idx="6">
                  <c:v>22.12324585196701</c:v>
                </c:pt>
                <c:pt idx="7">
                  <c:v>23.221981285013062</c:v>
                </c:pt>
                <c:pt idx="8">
                  <c:v>18.543136454923879</c:v>
                </c:pt>
                <c:pt idx="9">
                  <c:v>16.36420509070205</c:v>
                </c:pt>
                <c:pt idx="10">
                  <c:v>16.6701250550649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796800"/>
        <c:axId val="70798336"/>
      </c:scatterChart>
      <c:valAx>
        <c:axId val="70796800"/>
        <c:scaling>
          <c:logBase val="2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0798336"/>
        <c:crosses val="autoZero"/>
        <c:crossBetween val="midCat"/>
      </c:valAx>
      <c:valAx>
        <c:axId val="7079833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0796800"/>
        <c:crossesAt val="0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1696656770362698E-2"/>
          <c:y val="2.55402750491159E-2"/>
          <c:w val="0.78243900864850902"/>
          <c:h val="0.92466284052410896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1!$C$60</c:f>
              <c:strCache>
                <c:ptCount val="1"/>
                <c:pt idx="0">
                  <c:v>Cisplatin inhibition RHOXF2-shRNA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89:$C$99</c:f>
                <c:numCache>
                  <c:formatCode>General</c:formatCode>
                  <c:ptCount val="11"/>
                  <c:pt idx="0">
                    <c:v>0.970351212000509</c:v>
                  </c:pt>
                  <c:pt idx="1">
                    <c:v>0.80994118837334605</c:v>
                  </c:pt>
                  <c:pt idx="2">
                    <c:v>1.6105037301565821</c:v>
                  </c:pt>
                  <c:pt idx="3">
                    <c:v>2.0703161351483552</c:v>
                  </c:pt>
                  <c:pt idx="4">
                    <c:v>1.961804238493345</c:v>
                  </c:pt>
                  <c:pt idx="5">
                    <c:v>3.095939865223019</c:v>
                  </c:pt>
                  <c:pt idx="6">
                    <c:v>2.6277407751634541</c:v>
                  </c:pt>
                  <c:pt idx="7">
                    <c:v>2.9656693106107541</c:v>
                  </c:pt>
                  <c:pt idx="8">
                    <c:v>2.9054409903475218</c:v>
                  </c:pt>
                  <c:pt idx="9">
                    <c:v>1.689735931340745</c:v>
                  </c:pt>
                  <c:pt idx="10">
                    <c:v>2.542575547226396</c:v>
                  </c:pt>
                </c:numCache>
              </c:numRef>
            </c:plus>
            <c:minus>
              <c:numRef>
                <c:f>Sheet1!$C$89:$C$99</c:f>
                <c:numCache>
                  <c:formatCode>General</c:formatCode>
                  <c:ptCount val="11"/>
                  <c:pt idx="0">
                    <c:v>0.970351212000509</c:v>
                  </c:pt>
                  <c:pt idx="1">
                    <c:v>0.80994118837334605</c:v>
                  </c:pt>
                  <c:pt idx="2">
                    <c:v>1.6105037301565821</c:v>
                  </c:pt>
                  <c:pt idx="3">
                    <c:v>2.0703161351483552</c:v>
                  </c:pt>
                  <c:pt idx="4">
                    <c:v>1.961804238493345</c:v>
                  </c:pt>
                  <c:pt idx="5">
                    <c:v>3.095939865223019</c:v>
                  </c:pt>
                  <c:pt idx="6">
                    <c:v>2.6277407751634541</c:v>
                  </c:pt>
                  <c:pt idx="7">
                    <c:v>2.9656693106107541</c:v>
                  </c:pt>
                  <c:pt idx="8">
                    <c:v>2.9054409903475218</c:v>
                  </c:pt>
                  <c:pt idx="9">
                    <c:v>1.689735931340745</c:v>
                  </c:pt>
                  <c:pt idx="10">
                    <c:v>2.542575547226396</c:v>
                  </c:pt>
                </c:numCache>
              </c:numRef>
            </c:minus>
          </c:errBars>
          <c:xVal>
            <c:numRef>
              <c:f>Sheet1!$A$61:$A$71</c:f>
              <c:numCache>
                <c:formatCode>General</c:formatCode>
                <c:ptCount val="11"/>
                <c:pt idx="0">
                  <c:v>200</c:v>
                </c:pt>
                <c:pt idx="1">
                  <c:v>80</c:v>
                </c:pt>
                <c:pt idx="2">
                  <c:v>32</c:v>
                </c:pt>
                <c:pt idx="3">
                  <c:v>12.8</c:v>
                </c:pt>
                <c:pt idx="4">
                  <c:v>5.1199999999999974</c:v>
                </c:pt>
                <c:pt idx="5">
                  <c:v>2.048</c:v>
                </c:pt>
                <c:pt idx="6">
                  <c:v>0.81920000000000004</c:v>
                </c:pt>
                <c:pt idx="7">
                  <c:v>0.32768000000000003</c:v>
                </c:pt>
                <c:pt idx="8">
                  <c:v>0.13107199999999999</c:v>
                </c:pt>
                <c:pt idx="9">
                  <c:v>5.2428799999999998E-2</c:v>
                </c:pt>
                <c:pt idx="10">
                  <c:v>2.097152E-2</c:v>
                </c:pt>
              </c:numCache>
            </c:numRef>
          </c:xVal>
          <c:yVal>
            <c:numRef>
              <c:f>Sheet1!$C$61:$C$71</c:f>
              <c:numCache>
                <c:formatCode>General</c:formatCode>
                <c:ptCount val="11"/>
                <c:pt idx="0">
                  <c:v>83.657627816067645</c:v>
                </c:pt>
                <c:pt idx="1">
                  <c:v>86.013306542493495</c:v>
                </c:pt>
                <c:pt idx="2">
                  <c:v>84.219619377438462</c:v>
                </c:pt>
                <c:pt idx="3">
                  <c:v>58.125926616023229</c:v>
                </c:pt>
                <c:pt idx="4">
                  <c:v>38.556737050680013</c:v>
                </c:pt>
                <c:pt idx="5">
                  <c:v>35.145043277491837</c:v>
                </c:pt>
                <c:pt idx="6">
                  <c:v>23.254782955651301</c:v>
                </c:pt>
                <c:pt idx="7">
                  <c:v>21.561570024663791</c:v>
                </c:pt>
                <c:pt idx="8">
                  <c:v>15.546318804359069</c:v>
                </c:pt>
                <c:pt idx="9">
                  <c:v>14.084345185091699</c:v>
                </c:pt>
                <c:pt idx="10">
                  <c:v>17.22427122136256</c:v>
                </c:pt>
              </c:numCache>
            </c:numRef>
          </c:yVal>
          <c:smooth val="1"/>
        </c:ser>
        <c:ser>
          <c:idx val="6"/>
          <c:order val="1"/>
          <c:tx>
            <c:strRef>
              <c:f>Sheet1!$H$60</c:f>
              <c:strCache>
                <c:ptCount val="1"/>
                <c:pt idx="0">
                  <c:v>Cisplatin inhibition RHOXF2-GFP_3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 w="317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89:$H$99</c:f>
                <c:numCache>
                  <c:formatCode>General</c:formatCode>
                  <c:ptCount val="11"/>
                  <c:pt idx="0">
                    <c:v>0.62422316604903505</c:v>
                  </c:pt>
                  <c:pt idx="1">
                    <c:v>0.74757317698457104</c:v>
                  </c:pt>
                  <c:pt idx="2">
                    <c:v>1.9030300564614531</c:v>
                  </c:pt>
                  <c:pt idx="3">
                    <c:v>2.365622398365558</c:v>
                  </c:pt>
                  <c:pt idx="4">
                    <c:v>2.3447257810586022</c:v>
                  </c:pt>
                  <c:pt idx="5">
                    <c:v>2.536915469770467</c:v>
                  </c:pt>
                  <c:pt idx="6">
                    <c:v>1.538075887582683</c:v>
                  </c:pt>
                  <c:pt idx="7">
                    <c:v>1.736439845534351</c:v>
                  </c:pt>
                  <c:pt idx="8">
                    <c:v>0.530096198134962</c:v>
                  </c:pt>
                  <c:pt idx="9">
                    <c:v>0.91483382603429197</c:v>
                  </c:pt>
                  <c:pt idx="10">
                    <c:v>0.93776273439470403</c:v>
                  </c:pt>
                </c:numCache>
              </c:numRef>
            </c:plus>
            <c:minus>
              <c:numRef>
                <c:f>Sheet1!$H$89:$H$99</c:f>
                <c:numCache>
                  <c:formatCode>General</c:formatCode>
                  <c:ptCount val="11"/>
                  <c:pt idx="0">
                    <c:v>0.62422316604903505</c:v>
                  </c:pt>
                  <c:pt idx="1">
                    <c:v>0.74757317698457104</c:v>
                  </c:pt>
                  <c:pt idx="2">
                    <c:v>1.9030300564614531</c:v>
                  </c:pt>
                  <c:pt idx="3">
                    <c:v>2.365622398365558</c:v>
                  </c:pt>
                  <c:pt idx="4">
                    <c:v>2.3447257810586022</c:v>
                  </c:pt>
                  <c:pt idx="5">
                    <c:v>2.536915469770467</c:v>
                  </c:pt>
                  <c:pt idx="6">
                    <c:v>1.538075887582683</c:v>
                  </c:pt>
                  <c:pt idx="7">
                    <c:v>1.736439845534351</c:v>
                  </c:pt>
                  <c:pt idx="8">
                    <c:v>0.530096198134962</c:v>
                  </c:pt>
                  <c:pt idx="9">
                    <c:v>0.91483382603429197</c:v>
                  </c:pt>
                  <c:pt idx="10">
                    <c:v>0.93776273439470403</c:v>
                  </c:pt>
                </c:numCache>
              </c:numRef>
            </c:minus>
          </c:errBars>
          <c:xVal>
            <c:numRef>
              <c:f>Sheet1!$A$61:$A$71</c:f>
              <c:numCache>
                <c:formatCode>General</c:formatCode>
                <c:ptCount val="11"/>
                <c:pt idx="0">
                  <c:v>200</c:v>
                </c:pt>
                <c:pt idx="1">
                  <c:v>80</c:v>
                </c:pt>
                <c:pt idx="2">
                  <c:v>32</c:v>
                </c:pt>
                <c:pt idx="3">
                  <c:v>12.8</c:v>
                </c:pt>
                <c:pt idx="4">
                  <c:v>5.1199999999999974</c:v>
                </c:pt>
                <c:pt idx="5">
                  <c:v>2.048</c:v>
                </c:pt>
                <c:pt idx="6">
                  <c:v>0.81920000000000004</c:v>
                </c:pt>
                <c:pt idx="7">
                  <c:v>0.32768000000000003</c:v>
                </c:pt>
                <c:pt idx="8">
                  <c:v>0.13107199999999999</c:v>
                </c:pt>
                <c:pt idx="9">
                  <c:v>5.2428799999999998E-2</c:v>
                </c:pt>
                <c:pt idx="10">
                  <c:v>2.097152E-2</c:v>
                </c:pt>
              </c:numCache>
            </c:numRef>
          </c:xVal>
          <c:yVal>
            <c:numRef>
              <c:f>Sheet1!$H$61:$H$71</c:f>
              <c:numCache>
                <c:formatCode>General</c:formatCode>
                <c:ptCount val="11"/>
                <c:pt idx="0">
                  <c:v>82.988674493520548</c:v>
                </c:pt>
                <c:pt idx="1">
                  <c:v>87.311831649488425</c:v>
                </c:pt>
                <c:pt idx="2">
                  <c:v>82.768574865781247</c:v>
                </c:pt>
                <c:pt idx="3">
                  <c:v>59.148877095712713</c:v>
                </c:pt>
                <c:pt idx="4">
                  <c:v>41.215984671229833</c:v>
                </c:pt>
                <c:pt idx="5">
                  <c:v>36.618302669471419</c:v>
                </c:pt>
                <c:pt idx="6">
                  <c:v>25.52946722587544</c:v>
                </c:pt>
                <c:pt idx="7">
                  <c:v>18.995715280350399</c:v>
                </c:pt>
                <c:pt idx="8">
                  <c:v>12.37192352386195</c:v>
                </c:pt>
                <c:pt idx="9">
                  <c:v>11.13185701569396</c:v>
                </c:pt>
                <c:pt idx="10">
                  <c:v>18.11349711278445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823936"/>
        <c:axId val="70825472"/>
      </c:scatterChart>
      <c:valAx>
        <c:axId val="70823936"/>
        <c:scaling>
          <c:logBase val="2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0825472"/>
        <c:crosses val="autoZero"/>
        <c:crossBetween val="midCat"/>
      </c:valAx>
      <c:valAx>
        <c:axId val="7082547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0823936"/>
        <c:crossesAt val="0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6.3593522011751905E-2"/>
          <c:y val="2.30263157894737E-2"/>
          <c:w val="0.88208681135225397"/>
          <c:h val="0.936929910899295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1!$AJ$60</c:f>
              <c:strCache>
                <c:ptCount val="1"/>
                <c:pt idx="0">
                  <c:v>Mitomycin C inhibition RHOXF2-shRNA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J$89:$AJ$99</c:f>
                <c:numCache>
                  <c:formatCode>General</c:formatCode>
                  <c:ptCount val="11"/>
                  <c:pt idx="0">
                    <c:v>0.82767442030630201</c:v>
                  </c:pt>
                  <c:pt idx="1">
                    <c:v>1.0815401178123121</c:v>
                  </c:pt>
                  <c:pt idx="2">
                    <c:v>2.6964035581564199</c:v>
                  </c:pt>
                  <c:pt idx="3">
                    <c:v>2.8033331022004151</c:v>
                  </c:pt>
                  <c:pt idx="4">
                    <c:v>2.4038810270126252</c:v>
                  </c:pt>
                  <c:pt idx="5">
                    <c:v>1.280601712017529</c:v>
                  </c:pt>
                  <c:pt idx="6">
                    <c:v>3.3088183773217299</c:v>
                  </c:pt>
                  <c:pt idx="7">
                    <c:v>2.4020579024652671</c:v>
                  </c:pt>
                  <c:pt idx="8">
                    <c:v>2.9999859416449519</c:v>
                  </c:pt>
                  <c:pt idx="9">
                    <c:v>3.3675003322680128</c:v>
                  </c:pt>
                  <c:pt idx="10">
                    <c:v>1.906321781790336</c:v>
                  </c:pt>
                </c:numCache>
              </c:numRef>
            </c:plus>
            <c:minus>
              <c:numRef>
                <c:f>Sheet1!$AJ$89:$AJ$99</c:f>
                <c:numCache>
                  <c:formatCode>General</c:formatCode>
                  <c:ptCount val="11"/>
                  <c:pt idx="0">
                    <c:v>0.82767442030630201</c:v>
                  </c:pt>
                  <c:pt idx="1">
                    <c:v>1.0815401178123121</c:v>
                  </c:pt>
                  <c:pt idx="2">
                    <c:v>2.6964035581564199</c:v>
                  </c:pt>
                  <c:pt idx="3">
                    <c:v>2.8033331022004151</c:v>
                  </c:pt>
                  <c:pt idx="4">
                    <c:v>2.4038810270126252</c:v>
                  </c:pt>
                  <c:pt idx="5">
                    <c:v>1.280601712017529</c:v>
                  </c:pt>
                  <c:pt idx="6">
                    <c:v>3.3088183773217299</c:v>
                  </c:pt>
                  <c:pt idx="7">
                    <c:v>2.4020579024652671</c:v>
                  </c:pt>
                  <c:pt idx="8">
                    <c:v>2.9999859416449519</c:v>
                  </c:pt>
                  <c:pt idx="9">
                    <c:v>3.3675003322680128</c:v>
                  </c:pt>
                  <c:pt idx="10">
                    <c:v>1.906321781790336</c:v>
                  </c:pt>
                </c:numCache>
              </c:numRef>
            </c:minus>
          </c:errBars>
          <c:xVal>
            <c:numRef>
              <c:f>Sheet1!$AH$61:$AH$71</c:f>
              <c:numCache>
                <c:formatCode>General</c:formatCode>
                <c:ptCount val="11"/>
                <c:pt idx="0">
                  <c:v>20</c:v>
                </c:pt>
                <c:pt idx="1">
                  <c:v>8</c:v>
                </c:pt>
                <c:pt idx="2">
                  <c:v>3.2</c:v>
                </c:pt>
                <c:pt idx="3">
                  <c:v>1.28</c:v>
                </c:pt>
                <c:pt idx="4">
                  <c:v>0.51200000000000001</c:v>
                </c:pt>
                <c:pt idx="5">
                  <c:v>0.20480000000000001</c:v>
                </c:pt>
                <c:pt idx="6">
                  <c:v>8.1920000000000007E-2</c:v>
                </c:pt>
                <c:pt idx="7">
                  <c:v>3.2767999999999999E-2</c:v>
                </c:pt>
                <c:pt idx="8">
                  <c:v>1.3107199999999999E-2</c:v>
                </c:pt>
                <c:pt idx="9">
                  <c:v>5.2428800000000001E-3</c:v>
                </c:pt>
                <c:pt idx="10">
                  <c:v>2.0971520000000001E-3</c:v>
                </c:pt>
              </c:numCache>
            </c:numRef>
          </c:xVal>
          <c:yVal>
            <c:numRef>
              <c:f>Sheet1!$AJ$61:$AJ$71</c:f>
              <c:numCache>
                <c:formatCode>General</c:formatCode>
                <c:ptCount val="11"/>
                <c:pt idx="0">
                  <c:v>90.629230243618977</c:v>
                </c:pt>
                <c:pt idx="1">
                  <c:v>89.885988423976258</c:v>
                </c:pt>
                <c:pt idx="2">
                  <c:v>81.958727023788967</c:v>
                </c:pt>
                <c:pt idx="3">
                  <c:v>67.765471256948246</c:v>
                </c:pt>
                <c:pt idx="4">
                  <c:v>56.211079155483972</c:v>
                </c:pt>
                <c:pt idx="5">
                  <c:v>51.727746968725512</c:v>
                </c:pt>
                <c:pt idx="6">
                  <c:v>45.101151021708453</c:v>
                </c:pt>
                <c:pt idx="7">
                  <c:v>39.441877237326217</c:v>
                </c:pt>
                <c:pt idx="8">
                  <c:v>28.401918411095401</c:v>
                </c:pt>
                <c:pt idx="9">
                  <c:v>18.924026242212289</c:v>
                </c:pt>
                <c:pt idx="10">
                  <c:v>19.143949203818149</c:v>
                </c:pt>
              </c:numCache>
            </c:numRef>
          </c:yVal>
          <c:smooth val="1"/>
        </c:ser>
        <c:ser>
          <c:idx val="6"/>
          <c:order val="1"/>
          <c:tx>
            <c:strRef>
              <c:f>Sheet1!$AO$60</c:f>
              <c:strCache>
                <c:ptCount val="1"/>
                <c:pt idx="0">
                  <c:v>Cisplatin inhibition RHOXF2-GFP_3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O$89:$AO$99</c:f>
                <c:numCache>
                  <c:formatCode>General</c:formatCode>
                  <c:ptCount val="11"/>
                  <c:pt idx="0">
                    <c:v>0.385934665506315</c:v>
                  </c:pt>
                  <c:pt idx="1">
                    <c:v>0.479785099580186</c:v>
                  </c:pt>
                  <c:pt idx="2">
                    <c:v>2.5465705603634778</c:v>
                  </c:pt>
                  <c:pt idx="3">
                    <c:v>2.6119258525108289</c:v>
                  </c:pt>
                  <c:pt idx="4">
                    <c:v>3.18915372864782</c:v>
                  </c:pt>
                  <c:pt idx="5">
                    <c:v>1.775623363488074</c:v>
                  </c:pt>
                  <c:pt idx="6">
                    <c:v>1.1143847787426571</c:v>
                  </c:pt>
                  <c:pt idx="7">
                    <c:v>2.308508139834696</c:v>
                  </c:pt>
                  <c:pt idx="8">
                    <c:v>1.510174980404962</c:v>
                  </c:pt>
                  <c:pt idx="9">
                    <c:v>2.3942855656879578</c:v>
                  </c:pt>
                  <c:pt idx="10">
                    <c:v>1.527454043029562</c:v>
                  </c:pt>
                </c:numCache>
              </c:numRef>
            </c:plus>
            <c:minus>
              <c:numRef>
                <c:f>Sheet1!$AO$89:$AO$99</c:f>
                <c:numCache>
                  <c:formatCode>General</c:formatCode>
                  <c:ptCount val="11"/>
                  <c:pt idx="0">
                    <c:v>0.385934665506315</c:v>
                  </c:pt>
                  <c:pt idx="1">
                    <c:v>0.479785099580186</c:v>
                  </c:pt>
                  <c:pt idx="2">
                    <c:v>2.5465705603634778</c:v>
                  </c:pt>
                  <c:pt idx="3">
                    <c:v>2.6119258525108289</c:v>
                  </c:pt>
                  <c:pt idx="4">
                    <c:v>3.18915372864782</c:v>
                  </c:pt>
                  <c:pt idx="5">
                    <c:v>1.775623363488074</c:v>
                  </c:pt>
                  <c:pt idx="6">
                    <c:v>1.1143847787426571</c:v>
                  </c:pt>
                  <c:pt idx="7">
                    <c:v>2.308508139834696</c:v>
                  </c:pt>
                  <c:pt idx="8">
                    <c:v>1.510174980404962</c:v>
                  </c:pt>
                  <c:pt idx="9">
                    <c:v>2.3942855656879578</c:v>
                  </c:pt>
                  <c:pt idx="10">
                    <c:v>1.527454043029562</c:v>
                  </c:pt>
                </c:numCache>
              </c:numRef>
            </c:minus>
          </c:errBars>
          <c:xVal>
            <c:numRef>
              <c:f>Sheet1!$AH$61:$AH$71</c:f>
              <c:numCache>
                <c:formatCode>General</c:formatCode>
                <c:ptCount val="11"/>
                <c:pt idx="0">
                  <c:v>20</c:v>
                </c:pt>
                <c:pt idx="1">
                  <c:v>8</c:v>
                </c:pt>
                <c:pt idx="2">
                  <c:v>3.2</c:v>
                </c:pt>
                <c:pt idx="3">
                  <c:v>1.28</c:v>
                </c:pt>
                <c:pt idx="4">
                  <c:v>0.51200000000000001</c:v>
                </c:pt>
                <c:pt idx="5">
                  <c:v>0.20480000000000001</c:v>
                </c:pt>
                <c:pt idx="6">
                  <c:v>8.1920000000000007E-2</c:v>
                </c:pt>
                <c:pt idx="7">
                  <c:v>3.2767999999999999E-2</c:v>
                </c:pt>
                <c:pt idx="8">
                  <c:v>1.3107199999999999E-2</c:v>
                </c:pt>
                <c:pt idx="9">
                  <c:v>5.2428800000000001E-3</c:v>
                </c:pt>
                <c:pt idx="10">
                  <c:v>2.0971520000000001E-3</c:v>
                </c:pt>
              </c:numCache>
            </c:numRef>
          </c:xVal>
          <c:yVal>
            <c:numRef>
              <c:f>Sheet1!$AO$61:$AO$71</c:f>
              <c:numCache>
                <c:formatCode>General</c:formatCode>
                <c:ptCount val="11"/>
                <c:pt idx="0">
                  <c:v>91.156938110623528</c:v>
                </c:pt>
                <c:pt idx="1">
                  <c:v>90.174426735414045</c:v>
                </c:pt>
                <c:pt idx="2">
                  <c:v>80.106934970038395</c:v>
                </c:pt>
                <c:pt idx="3">
                  <c:v>66.401880276301782</c:v>
                </c:pt>
                <c:pt idx="4">
                  <c:v>59.130683105814249</c:v>
                </c:pt>
                <c:pt idx="5">
                  <c:v>48.359085790983023</c:v>
                </c:pt>
                <c:pt idx="6">
                  <c:v>46.304897610928798</c:v>
                </c:pt>
                <c:pt idx="7">
                  <c:v>36.048856477187869</c:v>
                </c:pt>
                <c:pt idx="8">
                  <c:v>27.351242950911981</c:v>
                </c:pt>
                <c:pt idx="9">
                  <c:v>20.97637161121111</c:v>
                </c:pt>
                <c:pt idx="10">
                  <c:v>21.0846580520055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912256"/>
        <c:axId val="70918144"/>
      </c:scatterChart>
      <c:valAx>
        <c:axId val="70912256"/>
        <c:scaling>
          <c:logBase val="2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0918144"/>
        <c:crosses val="autoZero"/>
        <c:crossBetween val="midCat"/>
      </c:valAx>
      <c:valAx>
        <c:axId val="7091814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0912256"/>
        <c:crossesAt val="0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6.3724335859886697E-2"/>
          <c:y val="3.9513677811550102E-2"/>
          <c:w val="0.91284112149532703"/>
          <c:h val="0.88344494172271004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1!$AJ$60</c:f>
              <c:strCache>
                <c:ptCount val="1"/>
                <c:pt idx="0">
                  <c:v>Mitomycin C inhibition RHOXF2-shRNA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J$89:$AJ$99</c:f>
                <c:numCache>
                  <c:formatCode>General</c:formatCode>
                  <c:ptCount val="11"/>
                  <c:pt idx="0">
                    <c:v>0.13583096574060999</c:v>
                  </c:pt>
                  <c:pt idx="1">
                    <c:v>1.3081016995491761</c:v>
                  </c:pt>
                  <c:pt idx="2">
                    <c:v>0.409751211566665</c:v>
                  </c:pt>
                  <c:pt idx="3">
                    <c:v>1.577853236262506</c:v>
                  </c:pt>
                  <c:pt idx="4">
                    <c:v>1.321537721029358</c:v>
                  </c:pt>
                  <c:pt idx="5">
                    <c:v>1.820346855575611</c:v>
                  </c:pt>
                  <c:pt idx="6">
                    <c:v>0.72786356947394604</c:v>
                  </c:pt>
                  <c:pt idx="7">
                    <c:v>1.330776567249597</c:v>
                  </c:pt>
                  <c:pt idx="8">
                    <c:v>1.189299815646905</c:v>
                  </c:pt>
                  <c:pt idx="9">
                    <c:v>2.292644518359428</c:v>
                  </c:pt>
                  <c:pt idx="10">
                    <c:v>13.9817428253132</c:v>
                  </c:pt>
                </c:numCache>
              </c:numRef>
            </c:plus>
            <c:minus>
              <c:numRef>
                <c:f>Sheet1!$AJ$89:$AJ$99</c:f>
                <c:numCache>
                  <c:formatCode>General</c:formatCode>
                  <c:ptCount val="11"/>
                  <c:pt idx="0">
                    <c:v>0.13583096574060999</c:v>
                  </c:pt>
                  <c:pt idx="1">
                    <c:v>1.3081016995491761</c:v>
                  </c:pt>
                  <c:pt idx="2">
                    <c:v>0.409751211566665</c:v>
                  </c:pt>
                  <c:pt idx="3">
                    <c:v>1.577853236262506</c:v>
                  </c:pt>
                  <c:pt idx="4">
                    <c:v>1.321537721029358</c:v>
                  </c:pt>
                  <c:pt idx="5">
                    <c:v>1.820346855575611</c:v>
                  </c:pt>
                  <c:pt idx="6">
                    <c:v>0.72786356947394604</c:v>
                  </c:pt>
                  <c:pt idx="7">
                    <c:v>1.330776567249597</c:v>
                  </c:pt>
                  <c:pt idx="8">
                    <c:v>1.189299815646905</c:v>
                  </c:pt>
                  <c:pt idx="9">
                    <c:v>2.292644518359428</c:v>
                  </c:pt>
                  <c:pt idx="10">
                    <c:v>13.9817428253132</c:v>
                  </c:pt>
                </c:numCache>
              </c:numRef>
            </c:minus>
          </c:errBars>
          <c:xVal>
            <c:numRef>
              <c:f>Sheet1!$AH$61:$AH$71</c:f>
              <c:numCache>
                <c:formatCode>General</c:formatCode>
                <c:ptCount val="11"/>
                <c:pt idx="0">
                  <c:v>20</c:v>
                </c:pt>
                <c:pt idx="1">
                  <c:v>8</c:v>
                </c:pt>
                <c:pt idx="2">
                  <c:v>3.2</c:v>
                </c:pt>
                <c:pt idx="3">
                  <c:v>1.28</c:v>
                </c:pt>
                <c:pt idx="4">
                  <c:v>0.51200000000000001</c:v>
                </c:pt>
                <c:pt idx="5">
                  <c:v>0.20480000000000001</c:v>
                </c:pt>
                <c:pt idx="6">
                  <c:v>8.1920000000000007E-2</c:v>
                </c:pt>
                <c:pt idx="7">
                  <c:v>3.2767999999999999E-2</c:v>
                </c:pt>
                <c:pt idx="8">
                  <c:v>1.3107199999999999E-2</c:v>
                </c:pt>
                <c:pt idx="9">
                  <c:v>5.2428800000000001E-3</c:v>
                </c:pt>
                <c:pt idx="10">
                  <c:v>2.0971520000000001E-3</c:v>
                </c:pt>
              </c:numCache>
            </c:numRef>
          </c:xVal>
          <c:yVal>
            <c:numRef>
              <c:f>Sheet1!$AJ$61:$AJ$71</c:f>
              <c:numCache>
                <c:formatCode>General</c:formatCode>
                <c:ptCount val="11"/>
                <c:pt idx="0">
                  <c:v>95.713577042773409</c:v>
                </c:pt>
                <c:pt idx="1">
                  <c:v>81.717041309630005</c:v>
                </c:pt>
                <c:pt idx="2">
                  <c:v>86.287069328542415</c:v>
                </c:pt>
                <c:pt idx="3">
                  <c:v>76.833939440865393</c:v>
                </c:pt>
                <c:pt idx="4">
                  <c:v>59.496341499132242</c:v>
                </c:pt>
                <c:pt idx="5">
                  <c:v>47.490161941381118</c:v>
                </c:pt>
                <c:pt idx="6">
                  <c:v>37.883643800949272</c:v>
                </c:pt>
                <c:pt idx="7">
                  <c:v>33.857050346682882</c:v>
                </c:pt>
                <c:pt idx="8">
                  <c:v>27.436472890011689</c:v>
                </c:pt>
                <c:pt idx="9">
                  <c:v>22.101078734137008</c:v>
                </c:pt>
                <c:pt idx="10">
                  <c:v>31.714881045347781</c:v>
                </c:pt>
              </c:numCache>
            </c:numRef>
          </c:yVal>
          <c:smooth val="1"/>
        </c:ser>
        <c:ser>
          <c:idx val="6"/>
          <c:order val="1"/>
          <c:tx>
            <c:strRef>
              <c:f>Sheet1!$AO$60</c:f>
              <c:strCache>
                <c:ptCount val="1"/>
                <c:pt idx="0">
                  <c:v>Mitomycin C inhibition RHOXF2-GFP_3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O$89:$AO$99</c:f>
                <c:numCache>
                  <c:formatCode>General</c:formatCode>
                  <c:ptCount val="11"/>
                  <c:pt idx="0">
                    <c:v>0.61822868005558695</c:v>
                  </c:pt>
                  <c:pt idx="1">
                    <c:v>0.90999448999130494</c:v>
                  </c:pt>
                  <c:pt idx="2">
                    <c:v>7.6304648275971901E-2</c:v>
                  </c:pt>
                  <c:pt idx="3">
                    <c:v>5.4063146699856466</c:v>
                  </c:pt>
                  <c:pt idx="4">
                    <c:v>5.7646583976940917</c:v>
                  </c:pt>
                  <c:pt idx="5">
                    <c:v>7.5829648771515954</c:v>
                  </c:pt>
                  <c:pt idx="6">
                    <c:v>7.1058351681675411</c:v>
                  </c:pt>
                  <c:pt idx="7">
                    <c:v>7.1759586127978077</c:v>
                  </c:pt>
                  <c:pt idx="8">
                    <c:v>6.1916597004766301</c:v>
                  </c:pt>
                  <c:pt idx="9">
                    <c:v>7.9153128885930837</c:v>
                  </c:pt>
                  <c:pt idx="10">
                    <c:v>6.8651509406964824</c:v>
                  </c:pt>
                </c:numCache>
              </c:numRef>
            </c:plus>
            <c:minus>
              <c:numRef>
                <c:f>Sheet1!$AO$89:$AO$99</c:f>
                <c:numCache>
                  <c:formatCode>General</c:formatCode>
                  <c:ptCount val="11"/>
                  <c:pt idx="0">
                    <c:v>0.61822868005558695</c:v>
                  </c:pt>
                  <c:pt idx="1">
                    <c:v>0.90999448999130494</c:v>
                  </c:pt>
                  <c:pt idx="2">
                    <c:v>7.6304648275971901E-2</c:v>
                  </c:pt>
                  <c:pt idx="3">
                    <c:v>5.4063146699856466</c:v>
                  </c:pt>
                  <c:pt idx="4">
                    <c:v>5.7646583976940917</c:v>
                  </c:pt>
                  <c:pt idx="5">
                    <c:v>7.5829648771515954</c:v>
                  </c:pt>
                  <c:pt idx="6">
                    <c:v>7.1058351681675411</c:v>
                  </c:pt>
                  <c:pt idx="7">
                    <c:v>7.1759586127978077</c:v>
                  </c:pt>
                  <c:pt idx="8">
                    <c:v>6.1916597004766301</c:v>
                  </c:pt>
                  <c:pt idx="9">
                    <c:v>7.9153128885930837</c:v>
                  </c:pt>
                  <c:pt idx="10">
                    <c:v>6.8651509406964824</c:v>
                  </c:pt>
                </c:numCache>
              </c:numRef>
            </c:minus>
          </c:errBars>
          <c:xVal>
            <c:numRef>
              <c:f>Sheet1!$AH$61:$AH$71</c:f>
              <c:numCache>
                <c:formatCode>General</c:formatCode>
                <c:ptCount val="11"/>
                <c:pt idx="0">
                  <c:v>20</c:v>
                </c:pt>
                <c:pt idx="1">
                  <c:v>8</c:v>
                </c:pt>
                <c:pt idx="2">
                  <c:v>3.2</c:v>
                </c:pt>
                <c:pt idx="3">
                  <c:v>1.28</c:v>
                </c:pt>
                <c:pt idx="4">
                  <c:v>0.51200000000000001</c:v>
                </c:pt>
                <c:pt idx="5">
                  <c:v>0.20480000000000001</c:v>
                </c:pt>
                <c:pt idx="6">
                  <c:v>8.1920000000000007E-2</c:v>
                </c:pt>
                <c:pt idx="7">
                  <c:v>3.2767999999999999E-2</c:v>
                </c:pt>
                <c:pt idx="8">
                  <c:v>1.3107199999999999E-2</c:v>
                </c:pt>
                <c:pt idx="9">
                  <c:v>5.2428800000000001E-3</c:v>
                </c:pt>
                <c:pt idx="10">
                  <c:v>2.0971520000000001E-3</c:v>
                </c:pt>
              </c:numCache>
            </c:numRef>
          </c:xVal>
          <c:yVal>
            <c:numRef>
              <c:f>Sheet1!$AO$61:$AO$71</c:f>
              <c:numCache>
                <c:formatCode>General</c:formatCode>
                <c:ptCount val="11"/>
                <c:pt idx="0">
                  <c:v>94.455164267472654</c:v>
                </c:pt>
                <c:pt idx="1">
                  <c:v>87.277465385891432</c:v>
                </c:pt>
                <c:pt idx="2">
                  <c:v>89.480725097069637</c:v>
                </c:pt>
                <c:pt idx="3">
                  <c:v>74.077403906022454</c:v>
                </c:pt>
                <c:pt idx="4">
                  <c:v>59.884067770687629</c:v>
                </c:pt>
                <c:pt idx="5">
                  <c:v>50.574619060759623</c:v>
                </c:pt>
                <c:pt idx="6">
                  <c:v>40.253705915011118</c:v>
                </c:pt>
                <c:pt idx="7">
                  <c:v>32.962391311278452</c:v>
                </c:pt>
                <c:pt idx="8">
                  <c:v>30.437326295811541</c:v>
                </c:pt>
                <c:pt idx="9">
                  <c:v>21.29001864506645</c:v>
                </c:pt>
                <c:pt idx="10">
                  <c:v>19.6406698792798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952064"/>
        <c:axId val="70953600"/>
      </c:scatterChart>
      <c:valAx>
        <c:axId val="70952064"/>
        <c:scaling>
          <c:logBase val="2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70953600"/>
        <c:crosses val="autoZero"/>
        <c:crossBetween val="midCat"/>
      </c:valAx>
      <c:valAx>
        <c:axId val="70953600"/>
        <c:scaling>
          <c:orientation val="minMax"/>
          <c:max val="10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0952064"/>
        <c:crossesAt val="0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943851644712601E-2"/>
          <c:y val="3.8575667655786301E-2"/>
          <c:w val="0.91278048421517399"/>
          <c:h val="0.88621182737914395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1!$C$60</c:f>
              <c:strCache>
                <c:ptCount val="1"/>
                <c:pt idx="0">
                  <c:v>Cisplatin inhibition RHOXF2-shRNA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89:$C$99</c:f>
                <c:numCache>
                  <c:formatCode>General</c:formatCode>
                  <c:ptCount val="11"/>
                  <c:pt idx="0">
                    <c:v>0.50906643625534498</c:v>
                  </c:pt>
                  <c:pt idx="1">
                    <c:v>1.2826086832755901</c:v>
                  </c:pt>
                  <c:pt idx="2">
                    <c:v>2.073945435203417</c:v>
                  </c:pt>
                  <c:pt idx="3">
                    <c:v>0.71684717050608504</c:v>
                  </c:pt>
                  <c:pt idx="4">
                    <c:v>1.4989071213507399</c:v>
                  </c:pt>
                  <c:pt idx="5">
                    <c:v>4.1298053782167402E-2</c:v>
                  </c:pt>
                  <c:pt idx="6">
                    <c:v>0.235516250342936</c:v>
                  </c:pt>
                  <c:pt idx="7">
                    <c:v>2.9663117064626499</c:v>
                  </c:pt>
                  <c:pt idx="8">
                    <c:v>3.5754271614234989</c:v>
                  </c:pt>
                  <c:pt idx="9">
                    <c:v>4.2518935206684194</c:v>
                  </c:pt>
                  <c:pt idx="10">
                    <c:v>8.9883188216077876</c:v>
                  </c:pt>
                </c:numCache>
              </c:numRef>
            </c:plus>
            <c:minus>
              <c:numRef>
                <c:f>Sheet1!$C$89:$C$99</c:f>
                <c:numCache>
                  <c:formatCode>General</c:formatCode>
                  <c:ptCount val="11"/>
                  <c:pt idx="0">
                    <c:v>0.50906643625534498</c:v>
                  </c:pt>
                  <c:pt idx="1">
                    <c:v>1.2826086832755901</c:v>
                  </c:pt>
                  <c:pt idx="2">
                    <c:v>2.073945435203417</c:v>
                  </c:pt>
                  <c:pt idx="3">
                    <c:v>0.71684717050608504</c:v>
                  </c:pt>
                  <c:pt idx="4">
                    <c:v>1.4989071213507399</c:v>
                  </c:pt>
                  <c:pt idx="5">
                    <c:v>4.1298053782167402E-2</c:v>
                  </c:pt>
                  <c:pt idx="6">
                    <c:v>0.235516250342936</c:v>
                  </c:pt>
                  <c:pt idx="7">
                    <c:v>2.9663117064626499</c:v>
                  </c:pt>
                  <c:pt idx="8">
                    <c:v>3.5754271614234989</c:v>
                  </c:pt>
                  <c:pt idx="9">
                    <c:v>4.2518935206684194</c:v>
                  </c:pt>
                  <c:pt idx="10">
                    <c:v>8.9883188216077876</c:v>
                  </c:pt>
                </c:numCache>
              </c:numRef>
            </c:minus>
          </c:errBars>
          <c:xVal>
            <c:numRef>
              <c:f>Sheet1!$A$61:$A$71</c:f>
              <c:numCache>
                <c:formatCode>General</c:formatCode>
                <c:ptCount val="11"/>
                <c:pt idx="0">
                  <c:v>200</c:v>
                </c:pt>
                <c:pt idx="1">
                  <c:v>80</c:v>
                </c:pt>
                <c:pt idx="2">
                  <c:v>32</c:v>
                </c:pt>
                <c:pt idx="3">
                  <c:v>12.8</c:v>
                </c:pt>
                <c:pt idx="4">
                  <c:v>5.1199999999999974</c:v>
                </c:pt>
                <c:pt idx="5">
                  <c:v>2.048</c:v>
                </c:pt>
                <c:pt idx="6">
                  <c:v>0.81920000000000004</c:v>
                </c:pt>
                <c:pt idx="7">
                  <c:v>0.32768000000000003</c:v>
                </c:pt>
                <c:pt idx="8">
                  <c:v>0.13107199999999999</c:v>
                </c:pt>
                <c:pt idx="9">
                  <c:v>5.2428799999999998E-2</c:v>
                </c:pt>
                <c:pt idx="10">
                  <c:v>2.097152E-2</c:v>
                </c:pt>
              </c:numCache>
            </c:numRef>
          </c:xVal>
          <c:yVal>
            <c:numRef>
              <c:f>Sheet1!$C$61:$C$71</c:f>
              <c:numCache>
                <c:formatCode>General</c:formatCode>
                <c:ptCount val="11"/>
                <c:pt idx="0">
                  <c:v>78.425788532835952</c:v>
                </c:pt>
                <c:pt idx="1">
                  <c:v>79.028685716085477</c:v>
                </c:pt>
                <c:pt idx="2">
                  <c:v>71.213270209335604</c:v>
                </c:pt>
                <c:pt idx="3">
                  <c:v>45.272244222336809</c:v>
                </c:pt>
                <c:pt idx="4">
                  <c:v>33.546266440227953</c:v>
                </c:pt>
                <c:pt idx="5">
                  <c:v>23.734260671847899</c:v>
                </c:pt>
                <c:pt idx="6">
                  <c:v>23.297808214204078</c:v>
                </c:pt>
                <c:pt idx="7">
                  <c:v>19.04985567347078</c:v>
                </c:pt>
                <c:pt idx="8">
                  <c:v>18.488291335961058</c:v>
                </c:pt>
                <c:pt idx="9">
                  <c:v>19.85652302712046</c:v>
                </c:pt>
                <c:pt idx="10">
                  <c:v>25.391139095653291</c:v>
                </c:pt>
              </c:numCache>
            </c:numRef>
          </c:yVal>
          <c:smooth val="1"/>
        </c:ser>
        <c:ser>
          <c:idx val="0"/>
          <c:order val="1"/>
          <c:tx>
            <c:strRef>
              <c:f>Sheet1!$G$60</c:f>
              <c:strCache>
                <c:ptCount val="1"/>
                <c:pt idx="0">
                  <c:v>Cisplatin inhibition RHOXF2-GFP_2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89:$G$99</c:f>
                <c:numCache>
                  <c:formatCode>General</c:formatCode>
                  <c:ptCount val="11"/>
                  <c:pt idx="0">
                    <c:v>6.0039851853225898E-2</c:v>
                  </c:pt>
                  <c:pt idx="1">
                    <c:v>0.47260882540170701</c:v>
                  </c:pt>
                  <c:pt idx="2">
                    <c:v>0.494614420216408</c:v>
                  </c:pt>
                  <c:pt idx="3">
                    <c:v>1.5980136632509949</c:v>
                  </c:pt>
                  <c:pt idx="4">
                    <c:v>0.91168934153140302</c:v>
                  </c:pt>
                  <c:pt idx="5">
                    <c:v>3.4250444465673371</c:v>
                  </c:pt>
                  <c:pt idx="6">
                    <c:v>6.5628157016639763</c:v>
                  </c:pt>
                  <c:pt idx="7">
                    <c:v>8.6397701882099707</c:v>
                  </c:pt>
                  <c:pt idx="8">
                    <c:v>8.0225145217481799</c:v>
                  </c:pt>
                  <c:pt idx="9">
                    <c:v>3.5214108604331269</c:v>
                  </c:pt>
                  <c:pt idx="10">
                    <c:v>4.0566802577773968</c:v>
                  </c:pt>
                </c:numCache>
              </c:numRef>
            </c:plus>
            <c:minus>
              <c:numRef>
                <c:f>Sheet1!$G$89:$G$99</c:f>
                <c:numCache>
                  <c:formatCode>General</c:formatCode>
                  <c:ptCount val="11"/>
                  <c:pt idx="0">
                    <c:v>6.0039851853225898E-2</c:v>
                  </c:pt>
                  <c:pt idx="1">
                    <c:v>0.47260882540170701</c:v>
                  </c:pt>
                  <c:pt idx="2">
                    <c:v>0.494614420216408</c:v>
                  </c:pt>
                  <c:pt idx="3">
                    <c:v>1.5980136632509949</c:v>
                  </c:pt>
                  <c:pt idx="4">
                    <c:v>0.91168934153140302</c:v>
                  </c:pt>
                  <c:pt idx="5">
                    <c:v>3.4250444465673371</c:v>
                  </c:pt>
                  <c:pt idx="6">
                    <c:v>6.5628157016639763</c:v>
                  </c:pt>
                  <c:pt idx="7">
                    <c:v>8.6397701882099707</c:v>
                  </c:pt>
                  <c:pt idx="8">
                    <c:v>8.0225145217481799</c:v>
                  </c:pt>
                  <c:pt idx="9">
                    <c:v>3.5214108604331269</c:v>
                  </c:pt>
                  <c:pt idx="10">
                    <c:v>4.0566802577773968</c:v>
                  </c:pt>
                </c:numCache>
              </c:numRef>
            </c:minus>
          </c:errBars>
          <c:xVal>
            <c:numRef>
              <c:f>Sheet1!$A$61:$A$71</c:f>
              <c:numCache>
                <c:formatCode>General</c:formatCode>
                <c:ptCount val="11"/>
                <c:pt idx="0">
                  <c:v>200</c:v>
                </c:pt>
                <c:pt idx="1">
                  <c:v>80</c:v>
                </c:pt>
                <c:pt idx="2">
                  <c:v>32</c:v>
                </c:pt>
                <c:pt idx="3">
                  <c:v>12.8</c:v>
                </c:pt>
                <c:pt idx="4">
                  <c:v>5.1199999999999974</c:v>
                </c:pt>
                <c:pt idx="5">
                  <c:v>2.048</c:v>
                </c:pt>
                <c:pt idx="6">
                  <c:v>0.81920000000000004</c:v>
                </c:pt>
                <c:pt idx="7">
                  <c:v>0.32768000000000003</c:v>
                </c:pt>
                <c:pt idx="8">
                  <c:v>0.13107199999999999</c:v>
                </c:pt>
                <c:pt idx="9">
                  <c:v>5.2428799999999998E-2</c:v>
                </c:pt>
                <c:pt idx="10">
                  <c:v>2.097152E-2</c:v>
                </c:pt>
              </c:numCache>
            </c:numRef>
          </c:xVal>
          <c:yVal>
            <c:numRef>
              <c:f>Sheet1!$G$61:$G$71</c:f>
              <c:numCache>
                <c:formatCode>General</c:formatCode>
                <c:ptCount val="11"/>
                <c:pt idx="0">
                  <c:v>72.944886256520945</c:v>
                </c:pt>
                <c:pt idx="1">
                  <c:v>77.064336987406151</c:v>
                </c:pt>
                <c:pt idx="2">
                  <c:v>66.89855530691591</c:v>
                </c:pt>
                <c:pt idx="3">
                  <c:v>44.652200855369223</c:v>
                </c:pt>
                <c:pt idx="4">
                  <c:v>33.32548244497967</c:v>
                </c:pt>
                <c:pt idx="5">
                  <c:v>24.016177451493419</c:v>
                </c:pt>
                <c:pt idx="6">
                  <c:v>20.947052154865951</c:v>
                </c:pt>
                <c:pt idx="7">
                  <c:v>15.437799744860209</c:v>
                </c:pt>
                <c:pt idx="8">
                  <c:v>20.928918462634869</c:v>
                </c:pt>
                <c:pt idx="9">
                  <c:v>18.496780318561079</c:v>
                </c:pt>
                <c:pt idx="10">
                  <c:v>12.33254232674292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048576"/>
        <c:axId val="71058560"/>
      </c:scatterChart>
      <c:valAx>
        <c:axId val="71048576"/>
        <c:scaling>
          <c:logBase val="2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71058560"/>
        <c:crosses val="autoZero"/>
        <c:crossBetween val="midCat"/>
      </c:valAx>
      <c:valAx>
        <c:axId val="7105856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71048576"/>
        <c:crossesAt val="0"/>
        <c:crossBetween val="midCat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040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90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898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228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79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18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038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538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120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986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25C90-14FF-B249-B2FA-9B6C001FB3F9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252E5-76BE-3248-9ACE-D98BB248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229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2.png"/><Relationship Id="rId7" Type="http://schemas.openxmlformats.org/officeDocument/2006/relationships/chart" Target="../charts/chart2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chart" Target="../charts/chart6.xml"/><Relationship Id="rId5" Type="http://schemas.openxmlformats.org/officeDocument/2006/relationships/image" Target="../media/image4.png"/><Relationship Id="rId10" Type="http://schemas.openxmlformats.org/officeDocument/2006/relationships/chart" Target="../charts/chart5.xml"/><Relationship Id="rId4" Type="http://schemas.openxmlformats.org/officeDocument/2006/relationships/image" Target="../media/image3.png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 rot="18008521">
            <a:off x="6180833" y="2633145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1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 rot="18008521">
            <a:off x="6496100" y="2633145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 rot="18008521">
            <a:off x="6776411" y="2633145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 rot="18008521">
            <a:off x="7056722" y="2633145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4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 rot="18008521">
            <a:off x="7337033" y="2633145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5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 rot="18008521">
            <a:off x="7680376" y="2707807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 rot="18008521">
            <a:off x="7960685" y="2707807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 rot="18008521">
            <a:off x="6053290" y="2896251"/>
            <a:ext cx="3259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WT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397532" y="3372793"/>
            <a:ext cx="4817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dirty="0" smtClean="0"/>
              <a:t>ubulin</a:t>
            </a:r>
            <a:endParaRPr lang="en-US" sz="800" dirty="0"/>
          </a:p>
        </p:txBody>
      </p:sp>
      <p:sp>
        <p:nvSpPr>
          <p:cNvPr id="13" name="TextBox 12"/>
          <p:cNvSpPr txBox="1"/>
          <p:nvPr/>
        </p:nvSpPr>
        <p:spPr>
          <a:xfrm>
            <a:off x="8397532" y="3160524"/>
            <a:ext cx="5246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RHOXF2</a:t>
            </a:r>
            <a:endParaRPr lang="en-US" sz="800" dirty="0"/>
          </a:p>
        </p:txBody>
      </p:sp>
      <p:sp>
        <p:nvSpPr>
          <p:cNvPr id="14" name="Rectangle 13"/>
          <p:cNvSpPr/>
          <p:nvPr/>
        </p:nvSpPr>
        <p:spPr>
          <a:xfrm>
            <a:off x="6890464" y="5986706"/>
            <a:ext cx="9640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SW1353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773808" y="3543127"/>
            <a:ext cx="11973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NCI-H1299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 rot="18008521">
            <a:off x="6178702" y="5014619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1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 rot="18008521">
            <a:off x="6498685" y="5014619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 rot="18008521">
            <a:off x="6793237" y="5014619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 rot="18008521">
            <a:off x="7087789" y="5014619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4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 rot="18008521">
            <a:off x="7400312" y="5014619"/>
            <a:ext cx="9344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RHOXF2-shRNA_5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 rot="18008521">
            <a:off x="7744117" y="5089281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2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 rot="18008521">
            <a:off x="8019620" y="5089281"/>
            <a:ext cx="76174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GFP-shRNA_3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23" name="Rectangle 22"/>
          <p:cNvSpPr/>
          <p:nvPr/>
        </p:nvSpPr>
        <p:spPr>
          <a:xfrm rot="18008521">
            <a:off x="6064476" y="5277725"/>
            <a:ext cx="3259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</a:rPr>
              <a:t>WT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397532" y="5767709"/>
            <a:ext cx="4817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dirty="0" smtClean="0"/>
              <a:t>ubulin</a:t>
            </a:r>
            <a:endParaRPr lang="en-US" sz="800" dirty="0"/>
          </a:p>
        </p:txBody>
      </p:sp>
      <p:sp>
        <p:nvSpPr>
          <p:cNvPr id="25" name="TextBox 24"/>
          <p:cNvSpPr txBox="1"/>
          <p:nvPr/>
        </p:nvSpPr>
        <p:spPr>
          <a:xfrm>
            <a:off x="8397532" y="5571334"/>
            <a:ext cx="5246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RHOXF2</a:t>
            </a:r>
            <a:endParaRPr lang="en-US" sz="800" dirty="0"/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3009" y="3425463"/>
            <a:ext cx="2401904" cy="134116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23009" y="3157947"/>
            <a:ext cx="2408000" cy="234704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23010" y="5804258"/>
            <a:ext cx="2401904" cy="164635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23010" y="5602967"/>
            <a:ext cx="2401904" cy="164635"/>
          </a:xfrm>
          <a:prstGeom prst="rect">
            <a:avLst/>
          </a:prstGeom>
        </p:spPr>
      </p:pic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4138569"/>
              </p:ext>
            </p:extLst>
          </p:nvPr>
        </p:nvGraphicFramePr>
        <p:xfrm>
          <a:off x="415314" y="4622808"/>
          <a:ext cx="2267894" cy="1998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2544295"/>
              </p:ext>
            </p:extLst>
          </p:nvPr>
        </p:nvGraphicFramePr>
        <p:xfrm>
          <a:off x="3321414" y="4669412"/>
          <a:ext cx="2254825" cy="19652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7524325"/>
              </p:ext>
            </p:extLst>
          </p:nvPr>
        </p:nvGraphicFramePr>
        <p:xfrm>
          <a:off x="433584" y="2319748"/>
          <a:ext cx="2240805" cy="20078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8678988"/>
              </p:ext>
            </p:extLst>
          </p:nvPr>
        </p:nvGraphicFramePr>
        <p:xfrm>
          <a:off x="3282666" y="2319750"/>
          <a:ext cx="2268900" cy="20078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0851248"/>
              </p:ext>
            </p:extLst>
          </p:nvPr>
        </p:nvGraphicFramePr>
        <p:xfrm>
          <a:off x="3291636" y="104859"/>
          <a:ext cx="2337769" cy="19817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2340103"/>
              </p:ext>
            </p:extLst>
          </p:nvPr>
        </p:nvGraphicFramePr>
        <p:xfrm>
          <a:off x="442142" y="104859"/>
          <a:ext cx="2256724" cy="19817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8" name="Rectangle 37"/>
          <p:cNvSpPr/>
          <p:nvPr/>
        </p:nvSpPr>
        <p:spPr>
          <a:xfrm>
            <a:off x="3744972" y="181257"/>
            <a:ext cx="7104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HPAC</a:t>
            </a:r>
            <a:endParaRPr lang="en-US" dirty="0">
              <a:solidFill>
                <a:srgbClr val="000000"/>
              </a:solidFill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1620906" y="1498624"/>
            <a:ext cx="982563" cy="317530"/>
            <a:chOff x="1980067" y="5427096"/>
            <a:chExt cx="982563" cy="317530"/>
          </a:xfrm>
        </p:grpSpPr>
        <p:cxnSp>
          <p:nvCxnSpPr>
            <p:cNvPr id="40" name="Straight Connector 39"/>
            <p:cNvCxnSpPr/>
            <p:nvPr/>
          </p:nvCxnSpPr>
          <p:spPr>
            <a:xfrm>
              <a:off x="1980067" y="55435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Oval 40"/>
            <p:cNvSpPr/>
            <p:nvPr/>
          </p:nvSpPr>
          <p:spPr>
            <a:xfrm>
              <a:off x="2081227" y="5518943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1983242" y="56578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2082525" y="5638800"/>
              <a:ext cx="45719" cy="46808"/>
            </a:xfrm>
            <a:prstGeom prst="rect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2175235" y="5427096"/>
              <a:ext cx="78739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smtClean="0"/>
                <a:t>RHOXF2_shRNA</a:t>
              </a:r>
              <a:endParaRPr lang="en-US" sz="700" dirty="0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2175235" y="5544571"/>
              <a:ext cx="63350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err="1" smtClean="0"/>
                <a:t>GFP_shRNA</a:t>
              </a:r>
              <a:endParaRPr lang="en-US" sz="700" dirty="0"/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4534856" y="1492259"/>
            <a:ext cx="982563" cy="317530"/>
            <a:chOff x="1980067" y="5427096"/>
            <a:chExt cx="982563" cy="317530"/>
          </a:xfrm>
        </p:grpSpPr>
        <p:cxnSp>
          <p:nvCxnSpPr>
            <p:cNvPr id="47" name="Straight Connector 46"/>
            <p:cNvCxnSpPr/>
            <p:nvPr/>
          </p:nvCxnSpPr>
          <p:spPr>
            <a:xfrm>
              <a:off x="1980067" y="55435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Oval 47"/>
            <p:cNvSpPr/>
            <p:nvPr/>
          </p:nvSpPr>
          <p:spPr>
            <a:xfrm>
              <a:off x="2081227" y="5518943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9" name="Straight Connector 48"/>
            <p:cNvCxnSpPr/>
            <p:nvPr/>
          </p:nvCxnSpPr>
          <p:spPr>
            <a:xfrm>
              <a:off x="1983242" y="56578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/>
            <p:cNvSpPr/>
            <p:nvPr/>
          </p:nvSpPr>
          <p:spPr>
            <a:xfrm>
              <a:off x="2082525" y="5638800"/>
              <a:ext cx="45719" cy="46808"/>
            </a:xfrm>
            <a:prstGeom prst="rect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175235" y="5427096"/>
              <a:ext cx="78739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smtClean="0"/>
                <a:t>RHOXF2_shRNA</a:t>
              </a:r>
              <a:endParaRPr lang="en-US" sz="700" dirty="0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2175235" y="5544571"/>
              <a:ext cx="63350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err="1" smtClean="0"/>
                <a:t>GFP_shRNA</a:t>
              </a:r>
              <a:endParaRPr lang="en-US" sz="700" dirty="0"/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1504470" y="3746392"/>
            <a:ext cx="982563" cy="317530"/>
            <a:chOff x="1980067" y="5427096"/>
            <a:chExt cx="982563" cy="317530"/>
          </a:xfrm>
        </p:grpSpPr>
        <p:cxnSp>
          <p:nvCxnSpPr>
            <p:cNvPr id="54" name="Straight Connector 53"/>
            <p:cNvCxnSpPr/>
            <p:nvPr/>
          </p:nvCxnSpPr>
          <p:spPr>
            <a:xfrm>
              <a:off x="1980067" y="55435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Oval 54"/>
            <p:cNvSpPr/>
            <p:nvPr/>
          </p:nvSpPr>
          <p:spPr>
            <a:xfrm>
              <a:off x="2081227" y="5518943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1983242" y="56578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/>
            <p:cNvSpPr/>
            <p:nvPr/>
          </p:nvSpPr>
          <p:spPr>
            <a:xfrm>
              <a:off x="2082525" y="5638800"/>
              <a:ext cx="45719" cy="46808"/>
            </a:xfrm>
            <a:prstGeom prst="rect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175235" y="5427096"/>
              <a:ext cx="78739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smtClean="0"/>
                <a:t>RHOXF2_shRNA</a:t>
              </a:r>
              <a:endParaRPr lang="en-US" sz="700" dirty="0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2175235" y="5544571"/>
              <a:ext cx="63350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err="1" smtClean="0"/>
                <a:t>GFP_shRNA</a:t>
              </a:r>
              <a:endParaRPr lang="en-US" sz="700" dirty="0"/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4455423" y="3733380"/>
            <a:ext cx="982563" cy="317530"/>
            <a:chOff x="1980067" y="5427096"/>
            <a:chExt cx="982563" cy="317530"/>
          </a:xfrm>
        </p:grpSpPr>
        <p:cxnSp>
          <p:nvCxnSpPr>
            <p:cNvPr id="61" name="Straight Connector 60"/>
            <p:cNvCxnSpPr/>
            <p:nvPr/>
          </p:nvCxnSpPr>
          <p:spPr>
            <a:xfrm>
              <a:off x="1980067" y="55435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Oval 61"/>
            <p:cNvSpPr/>
            <p:nvPr/>
          </p:nvSpPr>
          <p:spPr>
            <a:xfrm>
              <a:off x="2081227" y="5518943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3" name="Straight Connector 62"/>
            <p:cNvCxnSpPr/>
            <p:nvPr/>
          </p:nvCxnSpPr>
          <p:spPr>
            <a:xfrm>
              <a:off x="1983242" y="56578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/>
            <p:cNvSpPr/>
            <p:nvPr/>
          </p:nvSpPr>
          <p:spPr>
            <a:xfrm>
              <a:off x="2082525" y="5638800"/>
              <a:ext cx="45719" cy="46808"/>
            </a:xfrm>
            <a:prstGeom prst="rect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2175235" y="5427096"/>
              <a:ext cx="78739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smtClean="0"/>
                <a:t>RHOXF2_shRNA</a:t>
              </a:r>
              <a:endParaRPr lang="en-US" sz="700" dirty="0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2175235" y="5544571"/>
              <a:ext cx="63350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err="1" smtClean="0"/>
                <a:t>GFP_shRNA</a:t>
              </a:r>
              <a:endParaRPr lang="en-US" sz="700" dirty="0"/>
            </a:p>
          </p:txBody>
        </p:sp>
      </p:grpSp>
      <p:grpSp>
        <p:nvGrpSpPr>
          <p:cNvPr id="67" name="Group 66"/>
          <p:cNvGrpSpPr/>
          <p:nvPr/>
        </p:nvGrpSpPr>
        <p:grpSpPr>
          <a:xfrm>
            <a:off x="1598610" y="6036382"/>
            <a:ext cx="982563" cy="317530"/>
            <a:chOff x="1980067" y="5427096"/>
            <a:chExt cx="982563" cy="317530"/>
          </a:xfrm>
        </p:grpSpPr>
        <p:cxnSp>
          <p:nvCxnSpPr>
            <p:cNvPr id="68" name="Straight Connector 67"/>
            <p:cNvCxnSpPr/>
            <p:nvPr/>
          </p:nvCxnSpPr>
          <p:spPr>
            <a:xfrm>
              <a:off x="1980067" y="55435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Oval 68"/>
            <p:cNvSpPr/>
            <p:nvPr/>
          </p:nvSpPr>
          <p:spPr>
            <a:xfrm>
              <a:off x="2081227" y="5518943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0" name="Straight Connector 69"/>
            <p:cNvCxnSpPr/>
            <p:nvPr/>
          </p:nvCxnSpPr>
          <p:spPr>
            <a:xfrm>
              <a:off x="1983242" y="56578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/>
            <p:cNvSpPr/>
            <p:nvPr/>
          </p:nvSpPr>
          <p:spPr>
            <a:xfrm>
              <a:off x="2082525" y="5638800"/>
              <a:ext cx="45719" cy="46808"/>
            </a:xfrm>
            <a:prstGeom prst="rect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2175235" y="5427096"/>
              <a:ext cx="78739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smtClean="0"/>
                <a:t>RHOXF2_shRNA</a:t>
              </a:r>
              <a:endParaRPr lang="en-US" sz="700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2175235" y="5544571"/>
              <a:ext cx="63350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err="1" smtClean="0"/>
                <a:t>GFP_shRNA</a:t>
              </a:r>
              <a:endParaRPr lang="en-US" sz="700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4465504" y="6042814"/>
            <a:ext cx="982563" cy="317530"/>
            <a:chOff x="1980067" y="5427096"/>
            <a:chExt cx="982563" cy="317530"/>
          </a:xfrm>
        </p:grpSpPr>
        <p:cxnSp>
          <p:nvCxnSpPr>
            <p:cNvPr id="75" name="Straight Connector 74"/>
            <p:cNvCxnSpPr/>
            <p:nvPr/>
          </p:nvCxnSpPr>
          <p:spPr>
            <a:xfrm>
              <a:off x="1980067" y="55435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Oval 75"/>
            <p:cNvSpPr/>
            <p:nvPr/>
          </p:nvSpPr>
          <p:spPr>
            <a:xfrm>
              <a:off x="2081227" y="5518943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7" name="Straight Connector 76"/>
            <p:cNvCxnSpPr/>
            <p:nvPr/>
          </p:nvCxnSpPr>
          <p:spPr>
            <a:xfrm>
              <a:off x="1983242" y="5657850"/>
              <a:ext cx="2434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Rectangle 77"/>
            <p:cNvSpPr/>
            <p:nvPr/>
          </p:nvSpPr>
          <p:spPr>
            <a:xfrm>
              <a:off x="2082525" y="5638800"/>
              <a:ext cx="45719" cy="46808"/>
            </a:xfrm>
            <a:prstGeom prst="rect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2175235" y="5427096"/>
              <a:ext cx="78739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smtClean="0"/>
                <a:t>RHOXF2_shRNA</a:t>
              </a:r>
              <a:endParaRPr lang="en-US" sz="700" dirty="0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2175235" y="5544571"/>
              <a:ext cx="63350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b="1" dirty="0" err="1" smtClean="0"/>
                <a:t>GFP_shRNA</a:t>
              </a:r>
              <a:endParaRPr lang="en-US" sz="700" dirty="0"/>
            </a:p>
          </p:txBody>
        </p:sp>
      </p:grpSp>
      <p:sp>
        <p:nvSpPr>
          <p:cNvPr id="82" name="Rectangle 81"/>
          <p:cNvSpPr/>
          <p:nvPr/>
        </p:nvSpPr>
        <p:spPr>
          <a:xfrm rot="16200000">
            <a:off x="-427695" y="5188352"/>
            <a:ext cx="155425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200" b="1" dirty="0" smtClean="0"/>
              <a:t>Percentage inhibition</a:t>
            </a:r>
            <a:endParaRPr lang="en-US" sz="1200" dirty="0"/>
          </a:p>
        </p:txBody>
      </p:sp>
      <p:sp>
        <p:nvSpPr>
          <p:cNvPr id="84" name="Rectangle 83"/>
          <p:cNvSpPr/>
          <p:nvPr/>
        </p:nvSpPr>
        <p:spPr>
          <a:xfrm rot="16200000">
            <a:off x="2489879" y="5227803"/>
            <a:ext cx="155425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200" b="1" dirty="0" smtClean="0"/>
              <a:t>Percentage inhibition</a:t>
            </a:r>
            <a:endParaRPr lang="en-US" sz="1200" dirty="0"/>
          </a:p>
        </p:txBody>
      </p:sp>
      <p:sp>
        <p:nvSpPr>
          <p:cNvPr id="86" name="Rectangle 85"/>
          <p:cNvSpPr/>
          <p:nvPr/>
        </p:nvSpPr>
        <p:spPr>
          <a:xfrm rot="16200000">
            <a:off x="-405715" y="2900123"/>
            <a:ext cx="155425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200" b="1" dirty="0" smtClean="0"/>
              <a:t>Percentage inhibition</a:t>
            </a:r>
            <a:endParaRPr lang="en-US" sz="1200" dirty="0"/>
          </a:p>
        </p:txBody>
      </p:sp>
      <p:sp>
        <p:nvSpPr>
          <p:cNvPr id="87" name="Rectangle 86"/>
          <p:cNvSpPr/>
          <p:nvPr/>
        </p:nvSpPr>
        <p:spPr>
          <a:xfrm>
            <a:off x="4175161" y="4246168"/>
            <a:ext cx="14414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[</a:t>
            </a:r>
            <a:r>
              <a:rPr lang="en-US" sz="1200" b="1" dirty="0" err="1" smtClean="0"/>
              <a:t>mitomycin</a:t>
            </a:r>
            <a:r>
              <a:rPr lang="en-US" sz="1200" b="1" dirty="0" smtClean="0"/>
              <a:t> C] </a:t>
            </a:r>
            <a:r>
              <a:rPr lang="en-US" sz="1200" b="1" dirty="0"/>
              <a:t>(</a:t>
            </a:r>
            <a:r>
              <a:rPr lang="en-US" sz="1200" b="1" dirty="0" err="1"/>
              <a:t>μM</a:t>
            </a:r>
            <a:r>
              <a:rPr lang="en-US" sz="1200" b="1" dirty="0" smtClean="0"/>
              <a:t>)</a:t>
            </a:r>
            <a:endParaRPr lang="en-US" sz="1200" dirty="0"/>
          </a:p>
        </p:txBody>
      </p:sp>
      <p:sp>
        <p:nvSpPr>
          <p:cNvPr id="88" name="Rectangle 87"/>
          <p:cNvSpPr/>
          <p:nvPr/>
        </p:nvSpPr>
        <p:spPr>
          <a:xfrm rot="16200000">
            <a:off x="2488555" y="2892970"/>
            <a:ext cx="155425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200" b="1" dirty="0" smtClean="0"/>
              <a:t>Percentage inhibition</a:t>
            </a:r>
            <a:endParaRPr lang="en-US" sz="1200" dirty="0"/>
          </a:p>
        </p:txBody>
      </p:sp>
      <p:sp>
        <p:nvSpPr>
          <p:cNvPr id="90" name="Rectangle 89"/>
          <p:cNvSpPr/>
          <p:nvPr/>
        </p:nvSpPr>
        <p:spPr>
          <a:xfrm rot="16200000">
            <a:off x="-400818" y="678120"/>
            <a:ext cx="155425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200" b="1" dirty="0" smtClean="0"/>
              <a:t>Percentage inhibition</a:t>
            </a:r>
            <a:endParaRPr lang="en-US" sz="1200" dirty="0"/>
          </a:p>
        </p:txBody>
      </p:sp>
      <p:sp>
        <p:nvSpPr>
          <p:cNvPr id="92" name="Rectangle 91"/>
          <p:cNvSpPr/>
          <p:nvPr/>
        </p:nvSpPr>
        <p:spPr>
          <a:xfrm rot="16200000">
            <a:off x="2493452" y="682618"/>
            <a:ext cx="155425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200" b="1" dirty="0" smtClean="0"/>
              <a:t>Percentage inhibition</a:t>
            </a:r>
            <a:endParaRPr lang="en-US" sz="1200" dirty="0"/>
          </a:p>
        </p:txBody>
      </p:sp>
      <p:sp>
        <p:nvSpPr>
          <p:cNvPr id="95" name="Rectangle 94"/>
          <p:cNvSpPr/>
          <p:nvPr/>
        </p:nvSpPr>
        <p:spPr>
          <a:xfrm>
            <a:off x="873311" y="192908"/>
            <a:ext cx="7104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HPAC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96" name="Rectangle 95"/>
          <p:cNvSpPr/>
          <p:nvPr/>
        </p:nvSpPr>
        <p:spPr>
          <a:xfrm>
            <a:off x="796317" y="2373268"/>
            <a:ext cx="11973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NCI-H1299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97" name="Rectangle 96"/>
          <p:cNvSpPr/>
          <p:nvPr/>
        </p:nvSpPr>
        <p:spPr>
          <a:xfrm>
            <a:off x="3639630" y="2375466"/>
            <a:ext cx="11973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NCI-H1299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98" name="Rectangle 97"/>
          <p:cNvSpPr/>
          <p:nvPr/>
        </p:nvSpPr>
        <p:spPr>
          <a:xfrm>
            <a:off x="763776" y="4709910"/>
            <a:ext cx="9640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SW1353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3686527" y="4738011"/>
            <a:ext cx="9640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dirty="0" smtClean="0">
                <a:solidFill>
                  <a:srgbClr val="000000"/>
                </a:solidFill>
              </a:rPr>
              <a:t>SW1353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0131" y="4527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905046" y="4527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40131" y="2256339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905046" y="2256339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5720615" y="2256339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5720615" y="466941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2905046" y="466941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40131" y="4669412"/>
            <a:ext cx="341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32966" y="1875749"/>
            <a:ext cx="2222934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  0.01  0.05  0.25    1       4      16     64    256</a:t>
            </a:r>
            <a:endParaRPr lang="en-US" sz="900" dirty="0"/>
          </a:p>
        </p:txBody>
      </p:sp>
      <p:sp>
        <p:nvSpPr>
          <p:cNvPr id="89" name="Rectangle 88"/>
          <p:cNvSpPr/>
          <p:nvPr/>
        </p:nvSpPr>
        <p:spPr>
          <a:xfrm>
            <a:off x="1550054" y="1995645"/>
            <a:ext cx="11721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[</a:t>
            </a:r>
            <a:r>
              <a:rPr lang="en-US" sz="1200" b="1" dirty="0" err="1" smtClean="0"/>
              <a:t>cisplatin</a:t>
            </a:r>
            <a:r>
              <a:rPr lang="en-US" sz="1200" b="1" dirty="0" smtClean="0"/>
              <a:t>] (</a:t>
            </a:r>
            <a:r>
              <a:rPr lang="en-US" sz="1200" b="1" dirty="0" err="1" smtClean="0"/>
              <a:t>μM</a:t>
            </a:r>
            <a:r>
              <a:rPr lang="en-US" sz="1200" b="1" dirty="0" smtClean="0"/>
              <a:t>)</a:t>
            </a:r>
            <a:endParaRPr lang="en-US" sz="1200" dirty="0"/>
          </a:p>
        </p:txBody>
      </p:sp>
      <p:sp>
        <p:nvSpPr>
          <p:cNvPr id="115" name="TextBox 114"/>
          <p:cNvSpPr txBox="1"/>
          <p:nvPr/>
        </p:nvSpPr>
        <p:spPr>
          <a:xfrm>
            <a:off x="3372928" y="1873879"/>
            <a:ext cx="1611821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    0.00  0.01  0.03   0.13   0.5</a:t>
            </a:r>
            <a:endParaRPr lang="en-US" sz="900" dirty="0"/>
          </a:p>
        </p:txBody>
      </p:sp>
      <p:sp>
        <p:nvSpPr>
          <p:cNvPr id="116" name="TextBox 115"/>
          <p:cNvSpPr txBox="1"/>
          <p:nvPr/>
        </p:nvSpPr>
        <p:spPr>
          <a:xfrm>
            <a:off x="4838680" y="1873879"/>
            <a:ext cx="870521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2       8       32</a:t>
            </a:r>
            <a:endParaRPr lang="en-US" sz="900" dirty="0"/>
          </a:p>
        </p:txBody>
      </p:sp>
      <p:sp>
        <p:nvSpPr>
          <p:cNvPr id="91" name="Rectangle 90"/>
          <p:cNvSpPr/>
          <p:nvPr/>
        </p:nvSpPr>
        <p:spPr>
          <a:xfrm>
            <a:off x="4226666" y="2000863"/>
            <a:ext cx="14414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[</a:t>
            </a:r>
            <a:r>
              <a:rPr lang="en-US" sz="1200" b="1" dirty="0" err="1" smtClean="0"/>
              <a:t>mitomycin</a:t>
            </a:r>
            <a:r>
              <a:rPr lang="en-US" sz="1200" b="1" dirty="0" smtClean="0"/>
              <a:t> C] </a:t>
            </a:r>
            <a:r>
              <a:rPr lang="en-US" sz="1200" b="1" dirty="0"/>
              <a:t>(</a:t>
            </a:r>
            <a:r>
              <a:rPr lang="en-US" sz="1200" b="1" dirty="0" err="1"/>
              <a:t>μM</a:t>
            </a:r>
            <a:r>
              <a:rPr lang="en-US" sz="1200" b="1" dirty="0" smtClean="0"/>
              <a:t>)</a:t>
            </a:r>
            <a:endParaRPr lang="en-US" sz="1200" dirty="0"/>
          </a:p>
        </p:txBody>
      </p:sp>
      <p:sp>
        <p:nvSpPr>
          <p:cNvPr id="117" name="TextBox 116"/>
          <p:cNvSpPr txBox="1"/>
          <p:nvPr/>
        </p:nvSpPr>
        <p:spPr>
          <a:xfrm>
            <a:off x="513653" y="4118052"/>
            <a:ext cx="2222934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  0.01  0.05  0.25    1       4      16     64    256</a:t>
            </a:r>
            <a:endParaRPr lang="en-US" sz="900" dirty="0"/>
          </a:p>
        </p:txBody>
      </p:sp>
      <p:sp>
        <p:nvSpPr>
          <p:cNvPr id="85" name="Rectangle 84"/>
          <p:cNvSpPr/>
          <p:nvPr/>
        </p:nvSpPr>
        <p:spPr>
          <a:xfrm>
            <a:off x="1498549" y="4240950"/>
            <a:ext cx="11721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[</a:t>
            </a:r>
            <a:r>
              <a:rPr lang="en-US" sz="1200" b="1" dirty="0" err="1" smtClean="0"/>
              <a:t>cisplatin</a:t>
            </a:r>
            <a:r>
              <a:rPr lang="en-US" sz="1200" b="1" dirty="0" smtClean="0"/>
              <a:t>] (</a:t>
            </a:r>
            <a:r>
              <a:rPr lang="en-US" sz="1200" b="1" dirty="0" err="1" smtClean="0"/>
              <a:t>μM</a:t>
            </a:r>
            <a:r>
              <a:rPr lang="en-US" sz="1200" b="1" dirty="0" smtClean="0"/>
              <a:t>)</a:t>
            </a:r>
            <a:endParaRPr lang="en-US" sz="1200" dirty="0"/>
          </a:p>
        </p:txBody>
      </p:sp>
      <p:sp>
        <p:nvSpPr>
          <p:cNvPr id="118" name="TextBox 117"/>
          <p:cNvSpPr txBox="1"/>
          <p:nvPr/>
        </p:nvSpPr>
        <p:spPr>
          <a:xfrm>
            <a:off x="3316966" y="4116975"/>
            <a:ext cx="1611821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    0.00  0.01  0.03   0.13   0.5</a:t>
            </a:r>
            <a:endParaRPr lang="en-US" sz="900" dirty="0"/>
          </a:p>
        </p:txBody>
      </p:sp>
      <p:sp>
        <p:nvSpPr>
          <p:cNvPr id="119" name="TextBox 118"/>
          <p:cNvSpPr txBox="1"/>
          <p:nvPr/>
        </p:nvSpPr>
        <p:spPr>
          <a:xfrm>
            <a:off x="4782718" y="4116975"/>
            <a:ext cx="870521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2       8       32</a:t>
            </a:r>
            <a:endParaRPr lang="en-US" sz="900" dirty="0"/>
          </a:p>
        </p:txBody>
      </p:sp>
      <p:sp>
        <p:nvSpPr>
          <p:cNvPr id="120" name="TextBox 119"/>
          <p:cNvSpPr txBox="1"/>
          <p:nvPr/>
        </p:nvSpPr>
        <p:spPr>
          <a:xfrm>
            <a:off x="3323466" y="6417932"/>
            <a:ext cx="2222934" cy="2308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/>
              <a:t>     0.02     0.06     0.25       1          4          16</a:t>
            </a:r>
            <a:endParaRPr lang="en-US" sz="900" dirty="0"/>
          </a:p>
        </p:txBody>
      </p:sp>
      <p:sp>
        <p:nvSpPr>
          <p:cNvPr id="83" name="Rectangle 82"/>
          <p:cNvSpPr/>
          <p:nvPr/>
        </p:nvSpPr>
        <p:spPr>
          <a:xfrm>
            <a:off x="4164833" y="6546048"/>
            <a:ext cx="14414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[</a:t>
            </a:r>
            <a:r>
              <a:rPr lang="en-US" sz="1200" b="1" dirty="0" err="1" smtClean="0"/>
              <a:t>mitomycin</a:t>
            </a:r>
            <a:r>
              <a:rPr lang="en-US" sz="1200" b="1" dirty="0" smtClean="0"/>
              <a:t> C] </a:t>
            </a:r>
            <a:r>
              <a:rPr lang="en-US" sz="1200" b="1" dirty="0"/>
              <a:t>(</a:t>
            </a:r>
            <a:r>
              <a:rPr lang="en-US" sz="1200" b="1" dirty="0" err="1"/>
              <a:t>μM</a:t>
            </a:r>
            <a:r>
              <a:rPr lang="en-US" sz="1200" b="1" dirty="0" smtClean="0"/>
              <a:t>)</a:t>
            </a:r>
            <a:endParaRPr lang="en-US" sz="1200" dirty="0"/>
          </a:p>
        </p:txBody>
      </p:sp>
      <p:sp>
        <p:nvSpPr>
          <p:cNvPr id="81" name="Rectangle 80"/>
          <p:cNvSpPr/>
          <p:nvPr/>
        </p:nvSpPr>
        <p:spPr>
          <a:xfrm>
            <a:off x="1395005" y="6529179"/>
            <a:ext cx="11721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[</a:t>
            </a:r>
            <a:r>
              <a:rPr lang="en-US" sz="1200" b="1" dirty="0" err="1" smtClean="0"/>
              <a:t>cisplatin</a:t>
            </a:r>
            <a:r>
              <a:rPr lang="en-US" sz="1200" b="1" dirty="0" smtClean="0"/>
              <a:t>] (</a:t>
            </a:r>
            <a:r>
              <a:rPr lang="en-US" sz="1200" b="1" dirty="0" err="1" smtClean="0"/>
              <a:t>μM</a:t>
            </a:r>
            <a:r>
              <a:rPr lang="en-US" sz="1200" b="1" dirty="0" smtClean="0"/>
              <a:t>)</a:t>
            </a:r>
            <a:endParaRPr lang="en-US" sz="1200" dirty="0"/>
          </a:p>
        </p:txBody>
      </p:sp>
      <p:sp>
        <p:nvSpPr>
          <p:cNvPr id="121" name="TextBox 120"/>
          <p:cNvSpPr txBox="1"/>
          <p:nvPr/>
        </p:nvSpPr>
        <p:spPr>
          <a:xfrm>
            <a:off x="3379278" y="6257770"/>
            <a:ext cx="207258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sp>
        <p:nvSpPr>
          <p:cNvPr id="111" name="Rectangle 11"/>
          <p:cNvSpPr>
            <a:spLocks noChangeArrowheads="1"/>
          </p:cNvSpPr>
          <p:nvPr/>
        </p:nvSpPr>
        <p:spPr bwMode="auto">
          <a:xfrm>
            <a:off x="7503491" y="6465598"/>
            <a:ext cx="16706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sym typeface="Monotype Sorts" pitchFamily="-112" charset="2"/>
              </a:rPr>
              <a:t>Additional </a:t>
            </a:r>
            <a:r>
              <a:rPr lang="en-US" sz="1600" b="1" smtClean="0">
                <a:sym typeface="Monotype Sorts" pitchFamily="-112" charset="2"/>
              </a:rPr>
              <a:t>File </a:t>
            </a:r>
            <a:r>
              <a:rPr lang="en-US" sz="1600" b="1" smtClean="0">
                <a:sym typeface="Monotype Sorts" pitchFamily="-112" charset="2"/>
              </a:rPr>
              <a:t>12</a:t>
            </a:r>
            <a:endParaRPr lang="en-US" sz="1600" b="1" dirty="0">
              <a:sym typeface="Monotype Sorts" pitchFamily="-11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1264448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146</Words>
  <Application>Microsoft Office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Arnoldo</dc:creator>
  <cp:lastModifiedBy>Nuay, Michael</cp:lastModifiedBy>
  <cp:revision>51</cp:revision>
  <dcterms:created xsi:type="dcterms:W3CDTF">2012-03-09T21:58:10Z</dcterms:created>
  <dcterms:modified xsi:type="dcterms:W3CDTF">2014-05-20T08:15:00Z</dcterms:modified>
</cp:coreProperties>
</file>